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304" r:id="rId2"/>
    <p:sldId id="306" r:id="rId3"/>
    <p:sldId id="305" r:id="rId4"/>
  </p:sldIdLst>
  <p:sldSz cx="6858000" cy="9144000" type="screen4x3"/>
  <p:notesSz cx="6858000" cy="9144000"/>
  <p:defaultTextStyle>
    <a:defPPr>
      <a:defRPr lang="ja-JP"/>
    </a:defPPr>
    <a:lvl1pPr algn="l" defTabSz="457200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1pPr>
    <a:lvl2pPr marL="457200" algn="l" defTabSz="457200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2pPr>
    <a:lvl3pPr marL="914400" algn="l" defTabSz="457200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3pPr>
    <a:lvl4pPr marL="1371600" algn="l" defTabSz="457200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4pPr>
    <a:lvl5pPr marL="1828800" algn="l" defTabSz="457200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川口 誠" initials="" lastIdx="8" clrIdx="0"/>
  <p:cmAuthor id="1" name="EdanzQC-LD" initials="LD" lastIdx="1" clrIdx="1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AE2001"/>
    <a:srgbClr val="B63D06"/>
    <a:srgbClr val="00FF04"/>
    <a:srgbClr val="000CFF"/>
    <a:srgbClr val="431F02"/>
    <a:srgbClr val="6B3204"/>
    <a:srgbClr val="656565"/>
    <a:srgbClr val="66FF33"/>
    <a:srgbClr val="F73109"/>
    <a:srgbClr val="FF000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0354" autoAdjust="0"/>
    <p:restoredTop sz="96081" autoAdjust="0"/>
  </p:normalViewPr>
  <p:slideViewPr>
    <p:cSldViewPr snapToGrid="0" snapToObjects="1">
      <p:cViewPr>
        <p:scale>
          <a:sx n="125" d="100"/>
          <a:sy n="125" d="100"/>
        </p:scale>
        <p:origin x="3040" y="11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50" d="100"/>
        <a:sy n="150" d="100"/>
      </p:scale>
      <p:origin x="0" y="0"/>
    </p:cViewPr>
  </p:sorterViewPr>
  <p:notesViewPr>
    <p:cSldViewPr snapToGrid="0" snapToObjects="1">
      <p:cViewPr>
        <p:scale>
          <a:sx n="200" d="100"/>
          <a:sy n="200" d="100"/>
        </p:scale>
        <p:origin x="-664" y="6648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notesMaster" Target="notesMasters/notesMaster1.xml"/><Relationship Id="rId6" Type="http://schemas.openxmlformats.org/officeDocument/2006/relationships/commentAuthors" Target="commentAuthors.xml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Arial" charset="0"/>
                <a:ea typeface="ＭＳ Ｐゴシック" charset="0"/>
                <a:cs typeface="ＭＳ Ｐゴシック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05F87B0D-44C9-5A4C-9782-717EC4807004}" type="datetime1">
              <a:rPr lang="ja-JP" altLang="en-US"/>
              <a:pPr/>
              <a:t>2016/9/24</a:t>
            </a:fld>
            <a:endParaRPr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ja-JP" altLang="en-US" noProof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Arial" charset="0"/>
                <a:ea typeface="ＭＳ Ｐゴシック" charset="0"/>
                <a:cs typeface="ＭＳ Ｐゴシック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AB0DA982-38DC-5B49-B0C7-D64CD330720D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764249471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defTabSz="457200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ＭＳ Ｐゴシック" charset="0"/>
      </a:defRPr>
    </a:lvl1pPr>
    <a:lvl2pPr marL="457200" algn="l" defTabSz="457200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/>
              <a:t>マスター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90F0C62B-9CE1-A94B-B50B-6DE92DF67B24}" type="datetime1">
              <a:rPr lang="ja-JP" altLang="en-US"/>
              <a:pPr/>
              <a:t>2016/9/24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6398490-5B13-A840-82B3-723200ABF226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2419393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1F62B24F-10B2-704E-AA8D-5E83BA719D83}" type="datetime1">
              <a:rPr lang="ja-JP" altLang="en-US"/>
              <a:pPr/>
              <a:t>2016/9/24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CD5F7AE-6672-FB47-A018-58486C3A016D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6964378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696093A2-9F4B-B049-A145-555F83E5F9B3}" type="datetime1">
              <a:rPr lang="ja-JP" altLang="en-US"/>
              <a:pPr/>
              <a:t>2016/9/24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271A6CF-9782-5F4A-909B-B4A7D71AA882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91004019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>
  <p:cSld name="1_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コンテンツ プレースホルダ 1"/>
          <p:cNvSpPr>
            <a:spLocks noGrp="1"/>
          </p:cNvSpPr>
          <p:nvPr>
            <p:ph/>
          </p:nvPr>
        </p:nvSpPr>
        <p:spPr>
          <a:xfrm>
            <a:off x="342900" y="366713"/>
            <a:ext cx="6172200" cy="780097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3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1322C393-85A0-5B4A-9DB2-EE3430776E10}" type="datetime1">
              <a:rPr lang="ja-JP" altLang="en-US"/>
              <a:pPr/>
              <a:t>2016/9/24</a:t>
            </a:fld>
            <a:endParaRPr lang="ja-JP" altLang="en-US"/>
          </a:p>
        </p:txBody>
      </p:sp>
      <p:sp>
        <p:nvSpPr>
          <p:cNvPr id="4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D3A3701-EC32-2240-BC78-A573CC4C15AB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6940968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1D79306B-7876-DD44-962C-680F97A1FFED}" type="datetime1">
              <a:rPr lang="ja-JP" altLang="en-US"/>
              <a:pPr/>
              <a:t>2016/9/24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8F60E06-4F7D-A447-B960-DA9DD4105D2F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2752827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131D1E19-9F10-AD42-BC35-0943E5A34537}" type="datetime1">
              <a:rPr lang="ja-JP" altLang="en-US"/>
              <a:pPr/>
              <a:t>2016/9/24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7052959-0892-1946-AAB5-A36CFF8B52D7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7160119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2AA69F60-9BF4-FF4B-A1D6-B255ABE02BFE}" type="datetime1">
              <a:rPr lang="ja-JP" altLang="en-US"/>
              <a:pPr/>
              <a:t>2016/9/24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57494E5-AE04-6141-8617-3F3AC3C057EF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51093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08254555-1EC6-C440-AC30-5D3E84C724AC}" type="datetime1">
              <a:rPr lang="ja-JP" altLang="en-US"/>
              <a:pPr/>
              <a:t>2016/9/24</a:t>
            </a:fld>
            <a:endParaRPr lang="ja-JP" altLang="en-US"/>
          </a:p>
        </p:txBody>
      </p:sp>
      <p:sp>
        <p:nvSpPr>
          <p:cNvPr id="8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3FA3433-FD7B-2342-B540-2C16BF188CF6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1420627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9E0E183D-5FA3-6E43-9FE3-F2BD80A56053}" type="datetime1">
              <a:rPr lang="ja-JP" altLang="en-US"/>
              <a:pPr/>
              <a:t>2016/9/24</a:t>
            </a:fld>
            <a:endParaRPr lang="ja-JP" altLang="en-US"/>
          </a:p>
        </p:txBody>
      </p:sp>
      <p:sp>
        <p:nvSpPr>
          <p:cNvPr id="4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4940D1E-E624-4643-A3E1-720E4096CA86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5362714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A38919C1-5458-6041-BFB3-81B872F010BD}" type="datetime1">
              <a:rPr lang="ja-JP" altLang="en-US"/>
              <a:pPr/>
              <a:t>2016/9/24</a:t>
            </a:fld>
            <a:endParaRPr lang="ja-JP" altLang="en-US"/>
          </a:p>
        </p:txBody>
      </p:sp>
      <p:sp>
        <p:nvSpPr>
          <p:cNvPr id="3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8527028-7855-A64E-AF4E-32197E58FEC0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0301045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E63DFE7-250E-0F44-B3D9-E141F538DB18}" type="datetime1">
              <a:rPr lang="ja-JP" altLang="en-US"/>
              <a:pPr/>
              <a:t>2016/9/24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E61F029-A711-5D4A-9F08-DC84A128C0D4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4078456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ja-JP" altLang="en-US" noProof="0"/>
              <a:t>プレースホルダーまでドラッグするかアイコンをクリックして図を追加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15AC51B3-5A2F-EB42-9F08-58777C557CB1}" type="datetime1">
              <a:rPr lang="ja-JP" altLang="en-US"/>
              <a:pPr/>
              <a:t>2016/9/24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632CC4C-FA1D-0544-AE31-5FB958FBC4D9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9540467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slideLayout" Target="../slideLayouts/slideLayout12.xml"/><Relationship Id="rId13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FAA26D3D-D897-4be2-8F04-BA451C77F1D7}">
              <ma14:placeholderFlag xmlns:ma14="http://schemas.microsoft.com/office/mac/drawingml/2011/main" val="1"/>
            </a:ex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  <p:sp>
        <p:nvSpPr>
          <p:cNvPr id="1027" name="テキスト プレースホルダ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FAA26D3D-D897-4be2-8F04-BA451C77F1D7}">
              <ma14:placeholderFlag xmlns:ma14="http://schemas.microsoft.com/office/mac/drawingml/2011/main" val="1"/>
            </a:ex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  <a:latin typeface="Calibri" charset="0"/>
              </a:defRPr>
            </a:lvl1pPr>
          </a:lstStyle>
          <a:p>
            <a:fld id="{AC42B365-7CDE-B245-BCD2-831D768378E7}" type="datetime1">
              <a:rPr lang="ja-JP" altLang="en-US"/>
              <a:pPr/>
              <a:t>2016/9/24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  <a:latin typeface="Calibri" charset="0"/>
              </a:defRPr>
            </a:lvl1pPr>
          </a:lstStyle>
          <a:p>
            <a:fld id="{4F897C75-2B6C-9948-8C3E-402CAAB627F1}" type="slidenum">
              <a:rPr lang="ja-JP" altLang="en-US"/>
              <a:pPr/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ctr" defTabSz="457200" rtl="0" eaLnBrk="1" fontAlgn="base" hangingPunct="1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ＭＳ Ｐゴシック" charset="-128"/>
        </a:defRPr>
      </a:lvl1pPr>
      <a:lvl2pPr algn="ctr" defTabSz="457200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2pPr>
      <a:lvl3pPr algn="ctr" defTabSz="457200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3pPr>
      <a:lvl4pPr algn="ctr" defTabSz="457200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4pPr>
      <a:lvl5pPr algn="ctr" defTabSz="457200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5pPr>
      <a:lvl6pPr marL="457200" algn="ctr" defTabSz="457200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6pPr>
      <a:lvl7pPr marL="914400" algn="ctr" defTabSz="457200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7pPr>
      <a:lvl8pPr marL="1371600" algn="ctr" defTabSz="457200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8pPr>
      <a:lvl9pPr marL="1828800" algn="ctr" defTabSz="457200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9pPr>
    </p:titleStyle>
    <p:bodyStyle>
      <a:lvl1pPr marL="342900" indent="-3429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ＭＳ Ｐゴシック" charset="-128"/>
        </a:defRPr>
      </a:lvl1pPr>
      <a:lvl2pPr marL="742950" indent="-28575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8.jpeg"/><Relationship Id="rId20" Type="http://schemas.openxmlformats.org/officeDocument/2006/relationships/image" Target="../media/image19.jpeg"/><Relationship Id="rId21" Type="http://schemas.openxmlformats.org/officeDocument/2006/relationships/image" Target="../media/image20.jpeg"/><Relationship Id="rId22" Type="http://schemas.openxmlformats.org/officeDocument/2006/relationships/image" Target="../media/image21.jpeg"/><Relationship Id="rId23" Type="http://schemas.openxmlformats.org/officeDocument/2006/relationships/image" Target="../media/image22.jpeg"/><Relationship Id="rId24" Type="http://schemas.openxmlformats.org/officeDocument/2006/relationships/image" Target="../media/image23.jpeg"/><Relationship Id="rId25" Type="http://schemas.openxmlformats.org/officeDocument/2006/relationships/image" Target="../media/image24.jpeg"/><Relationship Id="rId26" Type="http://schemas.openxmlformats.org/officeDocument/2006/relationships/image" Target="../media/image25.jpeg"/><Relationship Id="rId10" Type="http://schemas.openxmlformats.org/officeDocument/2006/relationships/image" Target="../media/image9.jpeg"/><Relationship Id="rId11" Type="http://schemas.openxmlformats.org/officeDocument/2006/relationships/image" Target="../media/image10.jpeg"/><Relationship Id="rId12" Type="http://schemas.openxmlformats.org/officeDocument/2006/relationships/image" Target="../media/image11.jpeg"/><Relationship Id="rId13" Type="http://schemas.openxmlformats.org/officeDocument/2006/relationships/image" Target="../media/image12.jpeg"/><Relationship Id="rId14" Type="http://schemas.openxmlformats.org/officeDocument/2006/relationships/image" Target="../media/image13.jpeg"/><Relationship Id="rId15" Type="http://schemas.openxmlformats.org/officeDocument/2006/relationships/image" Target="../media/image14.jpeg"/><Relationship Id="rId16" Type="http://schemas.openxmlformats.org/officeDocument/2006/relationships/image" Target="../media/image15.jpeg"/><Relationship Id="rId17" Type="http://schemas.openxmlformats.org/officeDocument/2006/relationships/image" Target="../media/image16.jpeg"/><Relationship Id="rId18" Type="http://schemas.openxmlformats.org/officeDocument/2006/relationships/image" Target="../media/image17.jpeg"/><Relationship Id="rId19" Type="http://schemas.openxmlformats.org/officeDocument/2006/relationships/image" Target="../media/image18.jpe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image" Target="../media/image3.jpeg"/><Relationship Id="rId5" Type="http://schemas.openxmlformats.org/officeDocument/2006/relationships/image" Target="../media/image4.jpeg"/><Relationship Id="rId6" Type="http://schemas.openxmlformats.org/officeDocument/2006/relationships/image" Target="../media/image5.jpeg"/><Relationship Id="rId7" Type="http://schemas.openxmlformats.org/officeDocument/2006/relationships/image" Target="../media/image6.jpeg"/><Relationship Id="rId8" Type="http://schemas.openxmlformats.org/officeDocument/2006/relationships/image" Target="../media/image7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テキスト ボックス 110"/>
          <p:cNvSpPr txBox="1"/>
          <p:nvPr/>
        </p:nvSpPr>
        <p:spPr>
          <a:xfrm>
            <a:off x="2449513" y="8466"/>
            <a:ext cx="19692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"/>
                <a:cs typeface="Times"/>
              </a:rPr>
              <a:t>Supplementary figure 4</a:t>
            </a:r>
            <a:endParaRPr kumimoji="1" lang="ja-JP" altLang="en-US" sz="1200" dirty="0">
              <a:latin typeface="Times"/>
              <a:cs typeface="Times"/>
            </a:endParaRPr>
          </a:p>
        </p:txBody>
      </p:sp>
      <p:sp>
        <p:nvSpPr>
          <p:cNvPr id="112" name="テキスト ボックス 111"/>
          <p:cNvSpPr txBox="1"/>
          <p:nvPr/>
        </p:nvSpPr>
        <p:spPr>
          <a:xfrm>
            <a:off x="1612926" y="781210"/>
            <a:ext cx="89049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E-cadherin</a:t>
            </a:r>
            <a:endParaRPr kumimoji="1" lang="ja-JP" altLang="en-US" sz="1050" dirty="0"/>
          </a:p>
        </p:txBody>
      </p:sp>
      <p:sp>
        <p:nvSpPr>
          <p:cNvPr id="113" name="テキスト ボックス 112"/>
          <p:cNvSpPr txBox="1"/>
          <p:nvPr/>
        </p:nvSpPr>
        <p:spPr>
          <a:xfrm>
            <a:off x="2322859" y="781210"/>
            <a:ext cx="6955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MB33</a:t>
            </a:r>
            <a:endParaRPr kumimoji="1" lang="ja-JP" altLang="en-US" sz="1050" dirty="0"/>
          </a:p>
        </p:txBody>
      </p:sp>
      <p:sp>
        <p:nvSpPr>
          <p:cNvPr id="117" name="テキスト ボックス 116"/>
          <p:cNvSpPr txBox="1"/>
          <p:nvPr/>
        </p:nvSpPr>
        <p:spPr>
          <a:xfrm>
            <a:off x="2881950" y="781210"/>
            <a:ext cx="55943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MB34</a:t>
            </a:r>
            <a:endParaRPr kumimoji="1" lang="ja-JP" altLang="en-US" sz="1050" dirty="0"/>
          </a:p>
        </p:txBody>
      </p:sp>
      <p:sp>
        <p:nvSpPr>
          <p:cNvPr id="118" name="テキスト ボックス 117"/>
          <p:cNvSpPr txBox="1"/>
          <p:nvPr/>
        </p:nvSpPr>
        <p:spPr>
          <a:xfrm>
            <a:off x="3422892" y="781210"/>
            <a:ext cx="73002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MB39</a:t>
            </a:r>
            <a:endParaRPr kumimoji="1" lang="ja-JP" altLang="en-US" sz="1050" dirty="0"/>
          </a:p>
        </p:txBody>
      </p:sp>
      <p:sp>
        <p:nvSpPr>
          <p:cNvPr id="124" name="テキスト ボックス 123"/>
          <p:cNvSpPr txBox="1"/>
          <p:nvPr/>
        </p:nvSpPr>
        <p:spPr>
          <a:xfrm>
            <a:off x="4537863" y="781210"/>
            <a:ext cx="55909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/>
              <a:t>MB44</a:t>
            </a:r>
            <a:endParaRPr kumimoji="1" lang="ja-JP" altLang="en-US" sz="1050" dirty="0"/>
          </a:p>
        </p:txBody>
      </p:sp>
      <p:sp>
        <p:nvSpPr>
          <p:cNvPr id="125" name="テキスト ボックス 124"/>
          <p:cNvSpPr txBox="1"/>
          <p:nvPr/>
        </p:nvSpPr>
        <p:spPr>
          <a:xfrm>
            <a:off x="5088486" y="781210"/>
            <a:ext cx="61383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/>
              <a:t>MB47</a:t>
            </a:r>
            <a:endParaRPr kumimoji="1" lang="ja-JP" altLang="en-US" sz="1050" dirty="0"/>
          </a:p>
        </p:txBody>
      </p:sp>
      <p:sp>
        <p:nvSpPr>
          <p:cNvPr id="129" name="テキスト ボックス 128"/>
          <p:cNvSpPr txBox="1"/>
          <p:nvPr/>
        </p:nvSpPr>
        <p:spPr>
          <a:xfrm>
            <a:off x="5663846" y="781210"/>
            <a:ext cx="63961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/>
              <a:t>MB49</a:t>
            </a:r>
            <a:endParaRPr kumimoji="1" lang="ja-JP" altLang="en-US" sz="1050" dirty="0"/>
          </a:p>
        </p:txBody>
      </p:sp>
      <p:sp>
        <p:nvSpPr>
          <p:cNvPr id="130" name="テキスト ボックス 129"/>
          <p:cNvSpPr txBox="1"/>
          <p:nvPr/>
        </p:nvSpPr>
        <p:spPr>
          <a:xfrm>
            <a:off x="3933661" y="781210"/>
            <a:ext cx="68492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/>
              <a:t>D1-120</a:t>
            </a:r>
            <a:endParaRPr kumimoji="1" lang="ja-JP" altLang="en-US" sz="1050" dirty="0"/>
          </a:p>
        </p:txBody>
      </p:sp>
      <p:pic>
        <p:nvPicPr>
          <p:cNvPr id="131" name="図 130" descr="pH13-0954 12 MB33 x400-3.jp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757" t="21805" r="63184" b="64819"/>
          <a:stretch/>
        </p:blipFill>
        <p:spPr>
          <a:xfrm>
            <a:off x="2346600" y="5556036"/>
            <a:ext cx="512116" cy="389828"/>
          </a:xfrm>
          <a:prstGeom prst="rect">
            <a:avLst/>
          </a:prstGeom>
        </p:spPr>
      </p:pic>
      <p:pic>
        <p:nvPicPr>
          <p:cNvPr id="132" name="図 131" descr="pH13-0954 12 MB34 x400-3.jp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214" t="61664" r="37824" b="25051"/>
          <a:stretch/>
        </p:blipFill>
        <p:spPr>
          <a:xfrm>
            <a:off x="2897466" y="5556036"/>
            <a:ext cx="512116" cy="389828"/>
          </a:xfrm>
          <a:prstGeom prst="rect">
            <a:avLst/>
          </a:prstGeom>
        </p:spPr>
      </p:pic>
      <p:pic>
        <p:nvPicPr>
          <p:cNvPr id="156" name="図 155" descr="pH13-0954 12 MB39 x400-3.jpg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256" t="67511" r="9772" b="19138"/>
          <a:stretch/>
        </p:blipFill>
        <p:spPr>
          <a:xfrm>
            <a:off x="3448331" y="5556036"/>
            <a:ext cx="509951" cy="389828"/>
          </a:xfrm>
          <a:prstGeom prst="rect">
            <a:avLst/>
          </a:prstGeom>
        </p:spPr>
      </p:pic>
      <p:pic>
        <p:nvPicPr>
          <p:cNvPr id="157" name="図 156" descr="pH13-0954 12 D1-120 x400-3.jpg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275" t="30975" r="57698" b="55676"/>
          <a:stretch/>
        </p:blipFill>
        <p:spPr>
          <a:xfrm>
            <a:off x="3997032" y="5556037"/>
            <a:ext cx="512116" cy="389828"/>
          </a:xfrm>
          <a:prstGeom prst="rect">
            <a:avLst/>
          </a:prstGeom>
        </p:spPr>
      </p:pic>
      <p:pic>
        <p:nvPicPr>
          <p:cNvPr id="160" name="図 159" descr="pH13-0954 12 MB44 x400-3.jpg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23" t="70518" r="81459" b="16143"/>
          <a:stretch/>
        </p:blipFill>
        <p:spPr>
          <a:xfrm>
            <a:off x="4547897" y="5556035"/>
            <a:ext cx="512116" cy="389830"/>
          </a:xfrm>
          <a:prstGeom prst="rect">
            <a:avLst/>
          </a:prstGeom>
        </p:spPr>
      </p:pic>
      <p:pic>
        <p:nvPicPr>
          <p:cNvPr id="161" name="図 160" descr="pH13-0954 12 MB47 x400-3.jpg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702" t="33123" r="45303" b="53561"/>
          <a:stretch/>
        </p:blipFill>
        <p:spPr>
          <a:xfrm>
            <a:off x="5098763" y="5556036"/>
            <a:ext cx="512116" cy="389829"/>
          </a:xfrm>
          <a:prstGeom prst="rect">
            <a:avLst/>
          </a:prstGeom>
        </p:spPr>
      </p:pic>
      <p:pic>
        <p:nvPicPr>
          <p:cNvPr id="162" name="図 161" descr="pH13-0954 12 MB49 x400-3.jpg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209" t="31615" r="27804" b="55079"/>
          <a:stretch/>
        </p:blipFill>
        <p:spPr>
          <a:xfrm>
            <a:off x="5649626" y="5556036"/>
            <a:ext cx="512116" cy="389829"/>
          </a:xfrm>
          <a:prstGeom prst="rect">
            <a:avLst/>
          </a:prstGeom>
        </p:spPr>
      </p:pic>
      <p:grpSp>
        <p:nvGrpSpPr>
          <p:cNvPr id="163" name="図形グループ 162"/>
          <p:cNvGrpSpPr/>
          <p:nvPr/>
        </p:nvGrpSpPr>
        <p:grpSpPr>
          <a:xfrm>
            <a:off x="1796209" y="5057029"/>
            <a:ext cx="4370458" cy="389828"/>
            <a:chOff x="3103097" y="462498"/>
            <a:chExt cx="5392472" cy="480988"/>
          </a:xfrm>
        </p:grpSpPr>
        <p:pic>
          <p:nvPicPr>
            <p:cNvPr id="164" name="図 163" descr="pH13-0954 12 MB33 x400-1.jpg"/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737" t="18851" r="67586" b="70190"/>
            <a:stretch/>
          </p:blipFill>
          <p:spPr>
            <a:xfrm>
              <a:off x="3787890" y="469068"/>
              <a:ext cx="631872" cy="474418"/>
            </a:xfrm>
            <a:prstGeom prst="rect">
              <a:avLst/>
            </a:prstGeom>
          </p:spPr>
        </p:pic>
        <p:pic>
          <p:nvPicPr>
            <p:cNvPr id="165" name="図 164" descr="pH13-0954 12 MB34 x400-1.jpg"/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092" t="44141" r="36136" b="44812"/>
            <a:stretch/>
          </p:blipFill>
          <p:spPr>
            <a:xfrm>
              <a:off x="4467191" y="469068"/>
              <a:ext cx="631872" cy="474418"/>
            </a:xfrm>
            <a:prstGeom prst="rect">
              <a:avLst/>
            </a:prstGeom>
          </p:spPr>
        </p:pic>
        <p:pic>
          <p:nvPicPr>
            <p:cNvPr id="166" name="図 165" descr="pH13-0954 12 MB39 x400-1.jpg"/>
            <p:cNvPicPr>
              <a:picLocks noChangeAspect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276" t="21449" r="52910" b="67463"/>
            <a:stretch/>
          </p:blipFill>
          <p:spPr>
            <a:xfrm>
              <a:off x="5146492" y="469066"/>
              <a:ext cx="631872" cy="474420"/>
            </a:xfrm>
            <a:prstGeom prst="rect">
              <a:avLst/>
            </a:prstGeom>
          </p:spPr>
        </p:pic>
        <p:pic>
          <p:nvPicPr>
            <p:cNvPr id="173" name="図 172" descr="pH13-0954 12 D1-120 x400-1.jpg"/>
            <p:cNvPicPr>
              <a:picLocks noChangeAspect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658" t="1883" r="14465" b="86970"/>
            <a:stretch/>
          </p:blipFill>
          <p:spPr>
            <a:xfrm>
              <a:off x="5825793" y="469067"/>
              <a:ext cx="631872" cy="474419"/>
            </a:xfrm>
            <a:prstGeom prst="rect">
              <a:avLst/>
            </a:prstGeom>
          </p:spPr>
        </p:pic>
        <p:pic>
          <p:nvPicPr>
            <p:cNvPr id="174" name="図 173" descr="pH13-0954 12 MB44 x400-1.jpg"/>
            <p:cNvPicPr>
              <a:picLocks noChangeAspect="1"/>
            </p:cNvPicPr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455" t="30857" r="79748" b="58072"/>
            <a:stretch/>
          </p:blipFill>
          <p:spPr>
            <a:xfrm>
              <a:off x="6505094" y="469067"/>
              <a:ext cx="631872" cy="474419"/>
            </a:xfrm>
            <a:prstGeom prst="rect">
              <a:avLst/>
            </a:prstGeom>
          </p:spPr>
        </p:pic>
        <p:pic>
          <p:nvPicPr>
            <p:cNvPr id="177" name="図 176" descr="pH13-0954 12 MB47 x400-1.jpg"/>
            <p:cNvPicPr>
              <a:picLocks noChangeAspect="1"/>
            </p:cNvPicPr>
            <p:nvPr/>
          </p:nvPicPr>
          <p:blipFill rotWithShape="1"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42" t="27188" r="81461" b="61740"/>
            <a:stretch/>
          </p:blipFill>
          <p:spPr>
            <a:xfrm>
              <a:off x="7184395" y="469067"/>
              <a:ext cx="631873" cy="474419"/>
            </a:xfrm>
            <a:prstGeom prst="rect">
              <a:avLst/>
            </a:prstGeom>
          </p:spPr>
        </p:pic>
        <p:pic>
          <p:nvPicPr>
            <p:cNvPr id="179" name="図 178" descr="pH13-0954 12 MB49 x400-1.jpg"/>
            <p:cNvPicPr>
              <a:picLocks noChangeAspect="1"/>
            </p:cNvPicPr>
            <p:nvPr/>
          </p:nvPicPr>
          <p:blipFill rotWithShape="1"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679" t="24265" r="66554" b="64691"/>
            <a:stretch/>
          </p:blipFill>
          <p:spPr>
            <a:xfrm>
              <a:off x="7863697" y="469065"/>
              <a:ext cx="631872" cy="474421"/>
            </a:xfrm>
            <a:prstGeom prst="rect">
              <a:avLst/>
            </a:prstGeom>
          </p:spPr>
        </p:pic>
        <p:pic>
          <p:nvPicPr>
            <p:cNvPr id="181" name="図 180" descr="pH13-0954 12 E-cadherin x400-1.jpg"/>
            <p:cNvPicPr>
              <a:picLocks noChangeAspect="1"/>
            </p:cNvPicPr>
            <p:nvPr/>
          </p:nvPicPr>
          <p:blipFill rotWithShape="1"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188" t="43097" r="32182" b="44046"/>
            <a:stretch/>
          </p:blipFill>
          <p:spPr>
            <a:xfrm>
              <a:off x="3103097" y="462498"/>
              <a:ext cx="637364" cy="480988"/>
            </a:xfrm>
            <a:prstGeom prst="rect">
              <a:avLst/>
            </a:prstGeom>
          </p:spPr>
        </p:pic>
      </p:grpSp>
      <p:pic>
        <p:nvPicPr>
          <p:cNvPr id="183" name="図 182" descr="pH13-0954 12 E-cadherin x400-3.jpg"/>
          <p:cNvPicPr>
            <a:picLocks noChangeAspect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332" t="51584" r="16938" b="34400"/>
          <a:stretch/>
        </p:blipFill>
        <p:spPr>
          <a:xfrm>
            <a:off x="1795735" y="5556035"/>
            <a:ext cx="512116" cy="389828"/>
          </a:xfrm>
          <a:prstGeom prst="rect">
            <a:avLst/>
          </a:prstGeom>
        </p:spPr>
      </p:pic>
      <p:pic>
        <p:nvPicPr>
          <p:cNvPr id="184" name="図 183" descr="pH13-0954 12 縦長 HE x40.jpg"/>
          <p:cNvPicPr>
            <a:picLocks noChangeAspect="1"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815" t="22002" r="52751" b="7955"/>
          <a:stretch/>
        </p:blipFill>
        <p:spPr>
          <a:xfrm>
            <a:off x="1246353" y="1070034"/>
            <a:ext cx="516567" cy="3893097"/>
          </a:xfrm>
          <a:prstGeom prst="rect">
            <a:avLst/>
          </a:prstGeom>
        </p:spPr>
      </p:pic>
      <p:sp>
        <p:nvSpPr>
          <p:cNvPr id="186" name="左大かっこ 185"/>
          <p:cNvSpPr/>
          <p:nvPr/>
        </p:nvSpPr>
        <p:spPr>
          <a:xfrm>
            <a:off x="1057522" y="1587415"/>
            <a:ext cx="37054" cy="1899278"/>
          </a:xfrm>
          <a:prstGeom prst="leftBracket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sz="1050"/>
          </a:p>
        </p:txBody>
      </p:sp>
      <p:sp>
        <p:nvSpPr>
          <p:cNvPr id="191" name="左大かっこ 190"/>
          <p:cNvSpPr/>
          <p:nvPr/>
        </p:nvSpPr>
        <p:spPr>
          <a:xfrm>
            <a:off x="1057522" y="3569037"/>
            <a:ext cx="42885" cy="1386701"/>
          </a:xfrm>
          <a:prstGeom prst="leftBracket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sz="1050"/>
          </a:p>
        </p:txBody>
      </p:sp>
      <p:pic>
        <p:nvPicPr>
          <p:cNvPr id="192" name="図 191" descr="pH13-0954 12 縦長 E-cadhelin x40.jpg"/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278" t="24153" r="45351" b="5938"/>
          <a:stretch/>
        </p:blipFill>
        <p:spPr>
          <a:xfrm>
            <a:off x="1801582" y="1070034"/>
            <a:ext cx="512116" cy="3885705"/>
          </a:xfrm>
          <a:prstGeom prst="rect">
            <a:avLst/>
          </a:prstGeom>
        </p:spPr>
      </p:pic>
      <p:pic>
        <p:nvPicPr>
          <p:cNvPr id="194" name="図 193" descr="pH13-0954 12 縦長 MB33 x40.jpg"/>
          <p:cNvPicPr>
            <a:picLocks noChangeAspect="1"/>
          </p:cNvPicPr>
          <p:nvPr/>
        </p:nvPicPr>
        <p:blipFill rotWithShape="1"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116" t="20526" r="48513" b="9432"/>
          <a:stretch/>
        </p:blipFill>
        <p:spPr>
          <a:xfrm>
            <a:off x="2352359" y="1062640"/>
            <a:ext cx="512116" cy="3893098"/>
          </a:xfrm>
          <a:prstGeom prst="rect">
            <a:avLst/>
          </a:prstGeom>
        </p:spPr>
      </p:pic>
      <p:pic>
        <p:nvPicPr>
          <p:cNvPr id="197" name="図 196" descr="pH13-0954 12 縦長 MB34 x40.jpg"/>
          <p:cNvPicPr>
            <a:picLocks noChangeAspect="1"/>
          </p:cNvPicPr>
          <p:nvPr/>
        </p:nvPicPr>
        <p:blipFill rotWithShape="1"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007" t="12553" r="41622" b="17538"/>
          <a:stretch/>
        </p:blipFill>
        <p:spPr>
          <a:xfrm>
            <a:off x="2903136" y="1070034"/>
            <a:ext cx="512116" cy="3885704"/>
          </a:xfrm>
          <a:prstGeom prst="rect">
            <a:avLst/>
          </a:prstGeom>
        </p:spPr>
      </p:pic>
      <p:pic>
        <p:nvPicPr>
          <p:cNvPr id="199" name="図 198" descr="pH13-0954 12 縦長 MB39 x40.jpg"/>
          <p:cNvPicPr>
            <a:picLocks noChangeAspect="1"/>
          </p:cNvPicPr>
          <p:nvPr/>
        </p:nvPicPr>
        <p:blipFill rotWithShape="1"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458" t="14239" r="54171" b="15719"/>
          <a:stretch/>
        </p:blipFill>
        <p:spPr>
          <a:xfrm>
            <a:off x="3453913" y="1062640"/>
            <a:ext cx="512116" cy="3893099"/>
          </a:xfrm>
          <a:prstGeom prst="rect">
            <a:avLst/>
          </a:prstGeom>
        </p:spPr>
      </p:pic>
      <p:pic>
        <p:nvPicPr>
          <p:cNvPr id="206" name="図 205" descr="pH13-0954 12 縦長 D1-120 x40.jpg"/>
          <p:cNvPicPr>
            <a:picLocks noChangeAspect="1"/>
          </p:cNvPicPr>
          <p:nvPr/>
        </p:nvPicPr>
        <p:blipFill rotWithShape="1"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761" t="15066" r="36868" b="14760"/>
          <a:stretch/>
        </p:blipFill>
        <p:spPr>
          <a:xfrm>
            <a:off x="4004690" y="1062640"/>
            <a:ext cx="512116" cy="3900491"/>
          </a:xfrm>
          <a:prstGeom prst="rect">
            <a:avLst/>
          </a:prstGeom>
        </p:spPr>
      </p:pic>
      <p:pic>
        <p:nvPicPr>
          <p:cNvPr id="207" name="図 206" descr="pH13-0954 12 縦長 MB44 x40.jpg"/>
          <p:cNvPicPr>
            <a:picLocks noChangeAspect="1"/>
          </p:cNvPicPr>
          <p:nvPr/>
        </p:nvPicPr>
        <p:blipFill rotWithShape="1"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116" t="5614" r="48513" b="24212"/>
          <a:stretch/>
        </p:blipFill>
        <p:spPr>
          <a:xfrm>
            <a:off x="4555467" y="1062641"/>
            <a:ext cx="512116" cy="3900491"/>
          </a:xfrm>
          <a:prstGeom prst="rect">
            <a:avLst/>
          </a:prstGeom>
        </p:spPr>
      </p:pic>
      <p:pic>
        <p:nvPicPr>
          <p:cNvPr id="208" name="図 207" descr="pH13-0954 12 縦長 MB47 x40.jpg"/>
          <p:cNvPicPr>
            <a:picLocks noChangeAspect="1"/>
          </p:cNvPicPr>
          <p:nvPr/>
        </p:nvPicPr>
        <p:blipFill rotWithShape="1"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350" t="13877" r="39279" b="16081"/>
          <a:stretch/>
        </p:blipFill>
        <p:spPr>
          <a:xfrm>
            <a:off x="5106244" y="1062640"/>
            <a:ext cx="512116" cy="3893098"/>
          </a:xfrm>
          <a:prstGeom prst="rect">
            <a:avLst/>
          </a:prstGeom>
        </p:spPr>
      </p:pic>
      <p:pic>
        <p:nvPicPr>
          <p:cNvPr id="216" name="図 215" descr="pH13-0954 12 縦長 MB49 x40.jpg"/>
          <p:cNvPicPr>
            <a:picLocks noChangeAspect="1"/>
          </p:cNvPicPr>
          <p:nvPr/>
        </p:nvPicPr>
        <p:blipFill rotWithShape="1"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852" t="11944" r="49777" b="17881"/>
          <a:stretch/>
        </p:blipFill>
        <p:spPr>
          <a:xfrm>
            <a:off x="5657022" y="1062640"/>
            <a:ext cx="512116" cy="3900492"/>
          </a:xfrm>
          <a:prstGeom prst="rect">
            <a:avLst/>
          </a:prstGeom>
        </p:spPr>
      </p:pic>
      <p:sp>
        <p:nvSpPr>
          <p:cNvPr id="217" name="テキスト ボックス 216"/>
          <p:cNvSpPr txBox="1"/>
          <p:nvPr/>
        </p:nvSpPr>
        <p:spPr>
          <a:xfrm>
            <a:off x="691160" y="1182284"/>
            <a:ext cx="222422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Arial"/>
                <a:cs typeface="Arial"/>
              </a:rPr>
              <a:t>L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218" name="左大かっこ 217"/>
          <p:cNvSpPr/>
          <p:nvPr/>
        </p:nvSpPr>
        <p:spPr>
          <a:xfrm>
            <a:off x="1057522" y="1070034"/>
            <a:ext cx="42885" cy="467656"/>
          </a:xfrm>
          <a:prstGeom prst="leftBracket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sz="1050"/>
          </a:p>
        </p:txBody>
      </p:sp>
      <p:sp>
        <p:nvSpPr>
          <p:cNvPr id="227" name="テキスト ボックス 226"/>
          <p:cNvSpPr txBox="1"/>
          <p:nvPr/>
        </p:nvSpPr>
        <p:spPr>
          <a:xfrm>
            <a:off x="1057523" y="5630185"/>
            <a:ext cx="70539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Arial"/>
                <a:cs typeface="Arial"/>
              </a:rPr>
              <a:t>M </a:t>
            </a:r>
            <a:r>
              <a:rPr lang="en-US" altLang="ja-JP" sz="1050" dirty="0">
                <a:latin typeface="Arial"/>
                <a:cs typeface="Arial"/>
              </a:rPr>
              <a:t>zone</a:t>
            </a:r>
            <a:r>
              <a:rPr kumimoji="1" lang="en-US" altLang="ja-JP" sz="1050" dirty="0">
                <a:latin typeface="Arial"/>
                <a:cs typeface="Arial"/>
              </a:rPr>
              <a:t> 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228" name="テキスト ボックス 227"/>
          <p:cNvSpPr txBox="1"/>
          <p:nvPr/>
        </p:nvSpPr>
        <p:spPr>
          <a:xfrm>
            <a:off x="1057522" y="5184940"/>
            <a:ext cx="67659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Arial"/>
                <a:cs typeface="Arial"/>
              </a:rPr>
              <a:t>E </a:t>
            </a:r>
            <a:r>
              <a:rPr lang="en-US" altLang="ja-JP" sz="1050" dirty="0">
                <a:latin typeface="Arial"/>
                <a:cs typeface="Arial"/>
              </a:rPr>
              <a:t>zone</a:t>
            </a:r>
            <a:r>
              <a:rPr kumimoji="1" lang="en-US" altLang="ja-JP" sz="1050" dirty="0">
                <a:latin typeface="Arial"/>
                <a:cs typeface="Arial"/>
              </a:rPr>
              <a:t> 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236" name="テキスト ボックス 235"/>
          <p:cNvSpPr txBox="1"/>
          <p:nvPr/>
        </p:nvSpPr>
        <p:spPr>
          <a:xfrm>
            <a:off x="691160" y="2464831"/>
            <a:ext cx="232856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Arial"/>
                <a:cs typeface="Arial"/>
              </a:rPr>
              <a:t>E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237" name="テキスト ボックス 236"/>
          <p:cNvSpPr txBox="1"/>
          <p:nvPr/>
        </p:nvSpPr>
        <p:spPr>
          <a:xfrm>
            <a:off x="680726" y="4111462"/>
            <a:ext cx="253562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Arial"/>
                <a:cs typeface="Arial"/>
              </a:rPr>
              <a:t>M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238" name="テキスト ボックス 237"/>
          <p:cNvSpPr txBox="1"/>
          <p:nvPr/>
        </p:nvSpPr>
        <p:spPr>
          <a:xfrm>
            <a:off x="1315303" y="778176"/>
            <a:ext cx="47543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/>
              <a:t>HE</a:t>
            </a:r>
            <a:endParaRPr kumimoji="1" lang="ja-JP" altLang="en-US" sz="1050" dirty="0"/>
          </a:p>
        </p:txBody>
      </p:sp>
      <p:sp>
        <p:nvSpPr>
          <p:cNvPr id="239" name="テキスト ボックス 238"/>
          <p:cNvSpPr txBox="1"/>
          <p:nvPr/>
        </p:nvSpPr>
        <p:spPr>
          <a:xfrm>
            <a:off x="318229" y="593510"/>
            <a:ext cx="3086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/>
                <a:cs typeface="Arial"/>
              </a:rPr>
              <a:t>A</a:t>
            </a:r>
            <a:endParaRPr kumimoji="1" lang="ja-JP" altLang="en-US" sz="1200" b="1" dirty="0">
              <a:latin typeface="Arial"/>
              <a:cs typeface="Arial"/>
            </a:endParaRPr>
          </a:p>
        </p:txBody>
      </p:sp>
      <p:sp>
        <p:nvSpPr>
          <p:cNvPr id="240" name="テキスト ボックス 239"/>
          <p:cNvSpPr txBox="1"/>
          <p:nvPr/>
        </p:nvSpPr>
        <p:spPr>
          <a:xfrm>
            <a:off x="472540" y="6146132"/>
            <a:ext cx="29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/>
                <a:cs typeface="Arial"/>
              </a:rPr>
              <a:t>B</a:t>
            </a:r>
            <a:endParaRPr kumimoji="1" lang="ja-JP" altLang="en-US" sz="1200" b="1" dirty="0">
              <a:latin typeface="Arial"/>
              <a:cs typeface="Arial"/>
            </a:endParaRPr>
          </a:p>
        </p:txBody>
      </p:sp>
      <p:sp>
        <p:nvSpPr>
          <p:cNvPr id="241" name="円弧 240"/>
          <p:cNvSpPr/>
          <p:nvPr/>
        </p:nvSpPr>
        <p:spPr>
          <a:xfrm>
            <a:off x="1329819" y="7567626"/>
            <a:ext cx="3760013" cy="1461714"/>
          </a:xfrm>
          <a:prstGeom prst="arc">
            <a:avLst>
              <a:gd name="adj1" fmla="val 13893797"/>
              <a:gd name="adj2" fmla="val 18000197"/>
            </a:avLst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2" name="円弧 241"/>
          <p:cNvSpPr/>
          <p:nvPr/>
        </p:nvSpPr>
        <p:spPr>
          <a:xfrm>
            <a:off x="1338610" y="7625834"/>
            <a:ext cx="3760013" cy="1461714"/>
          </a:xfrm>
          <a:prstGeom prst="arc">
            <a:avLst>
              <a:gd name="adj1" fmla="val 13889752"/>
              <a:gd name="adj2" fmla="val 18032117"/>
            </a:avLst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3" name="円弧 242"/>
          <p:cNvSpPr/>
          <p:nvPr/>
        </p:nvSpPr>
        <p:spPr>
          <a:xfrm>
            <a:off x="1322688" y="7563003"/>
            <a:ext cx="3760013" cy="1461714"/>
          </a:xfrm>
          <a:prstGeom prst="arc">
            <a:avLst>
              <a:gd name="adj1" fmla="val 11960763"/>
              <a:gd name="adj2" fmla="val 13207449"/>
            </a:avLst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4" name="円弧 243"/>
          <p:cNvSpPr/>
          <p:nvPr/>
        </p:nvSpPr>
        <p:spPr>
          <a:xfrm>
            <a:off x="1322688" y="7618473"/>
            <a:ext cx="3760013" cy="1461714"/>
          </a:xfrm>
          <a:prstGeom prst="arc">
            <a:avLst>
              <a:gd name="adj1" fmla="val 11960763"/>
              <a:gd name="adj2" fmla="val 13216658"/>
            </a:avLst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5" name="円弧 244"/>
          <p:cNvSpPr/>
          <p:nvPr/>
        </p:nvSpPr>
        <p:spPr>
          <a:xfrm>
            <a:off x="1291092" y="7579953"/>
            <a:ext cx="3760013" cy="1461714"/>
          </a:xfrm>
          <a:prstGeom prst="arc">
            <a:avLst>
              <a:gd name="adj1" fmla="val 18933099"/>
              <a:gd name="adj2" fmla="val 20341105"/>
            </a:avLst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6" name="円弧 245"/>
          <p:cNvSpPr/>
          <p:nvPr/>
        </p:nvSpPr>
        <p:spPr>
          <a:xfrm>
            <a:off x="1282588" y="7640215"/>
            <a:ext cx="3760013" cy="1461714"/>
          </a:xfrm>
          <a:prstGeom prst="arc">
            <a:avLst>
              <a:gd name="adj1" fmla="val 18932707"/>
              <a:gd name="adj2" fmla="val 20341105"/>
            </a:avLst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7" name="Text Box 319"/>
          <p:cNvSpPr txBox="1">
            <a:spLocks noChangeArrowheads="1"/>
          </p:cNvSpPr>
          <p:nvPr/>
        </p:nvSpPr>
        <p:spPr bwMode="auto">
          <a:xfrm>
            <a:off x="3925430" y="8369375"/>
            <a:ext cx="1056806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r>
              <a:rPr lang="en-US" altLang="ja-JP" sz="1000" dirty="0">
                <a:latin typeface="Arial"/>
                <a:ea typeface="ヒラギノ明朝 Pro W3" charset="0"/>
                <a:cs typeface="Arial"/>
              </a:rPr>
              <a:t> </a:t>
            </a:r>
            <a:r>
              <a:rPr lang="en-US" altLang="ja-JP" sz="1000" i="1" dirty="0">
                <a:latin typeface="Arial"/>
                <a:ea typeface="ヒラギノ明朝 Pro W3" charset="0"/>
                <a:cs typeface="Arial"/>
              </a:rPr>
              <a:t>E cadherin</a:t>
            </a:r>
            <a:r>
              <a:rPr lang="en-US" altLang="ja-JP" sz="1000" dirty="0">
                <a:latin typeface="Arial"/>
                <a:ea typeface="ヒラギノ明朝 Pro W3" charset="0"/>
                <a:cs typeface="Arial"/>
              </a:rPr>
              <a:t> </a:t>
            </a:r>
          </a:p>
        </p:txBody>
      </p:sp>
      <p:sp>
        <p:nvSpPr>
          <p:cNvPr id="248" name="正方形/長方形 247"/>
          <p:cNvSpPr/>
          <p:nvPr/>
        </p:nvSpPr>
        <p:spPr>
          <a:xfrm>
            <a:off x="4343568" y="8577520"/>
            <a:ext cx="597954" cy="167641"/>
          </a:xfrm>
          <a:prstGeom prst="rect">
            <a:avLst/>
          </a:prstGeom>
          <a:solidFill>
            <a:srgbClr val="FFFFFF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9" name="Freeform 429"/>
          <p:cNvSpPr>
            <a:spLocks/>
          </p:cNvSpPr>
          <p:nvPr/>
        </p:nvSpPr>
        <p:spPr bwMode="auto">
          <a:xfrm>
            <a:off x="2127119" y="8605257"/>
            <a:ext cx="1471167" cy="113347"/>
          </a:xfrm>
          <a:custGeom>
            <a:avLst/>
            <a:gdLst>
              <a:gd name="T0" fmla="*/ 0 w 2054"/>
              <a:gd name="T1" fmla="*/ 102 h 105"/>
              <a:gd name="T2" fmla="*/ 101 w 2054"/>
              <a:gd name="T3" fmla="*/ 6 h 105"/>
              <a:gd name="T4" fmla="*/ 205 w 2054"/>
              <a:gd name="T5" fmla="*/ 104 h 105"/>
              <a:gd name="T6" fmla="*/ 309 w 2054"/>
              <a:gd name="T7" fmla="*/ 6 h 105"/>
              <a:gd name="T8" fmla="*/ 414 w 2054"/>
              <a:gd name="T9" fmla="*/ 104 h 105"/>
              <a:gd name="T10" fmla="*/ 524 w 2054"/>
              <a:gd name="T11" fmla="*/ 6 h 105"/>
              <a:gd name="T12" fmla="*/ 622 w 2054"/>
              <a:gd name="T13" fmla="*/ 104 h 105"/>
              <a:gd name="T14" fmla="*/ 727 w 2054"/>
              <a:gd name="T15" fmla="*/ 0 h 105"/>
              <a:gd name="T16" fmla="*/ 831 w 2054"/>
              <a:gd name="T17" fmla="*/ 104 h 105"/>
              <a:gd name="T18" fmla="*/ 930 w 2054"/>
              <a:gd name="T19" fmla="*/ 6 h 105"/>
              <a:gd name="T20" fmla="*/ 1034 w 2054"/>
              <a:gd name="T21" fmla="*/ 104 h 105"/>
              <a:gd name="T22" fmla="*/ 1138 w 2054"/>
              <a:gd name="T23" fmla="*/ 6 h 105"/>
              <a:gd name="T24" fmla="*/ 1243 w 2054"/>
              <a:gd name="T25" fmla="*/ 104 h 105"/>
              <a:gd name="T26" fmla="*/ 1347 w 2054"/>
              <a:gd name="T27" fmla="*/ 6 h 105"/>
              <a:gd name="T28" fmla="*/ 1451 w 2054"/>
              <a:gd name="T29" fmla="*/ 104 h 105"/>
              <a:gd name="T30" fmla="*/ 1556 w 2054"/>
              <a:gd name="T31" fmla="*/ 6 h 105"/>
              <a:gd name="T32" fmla="*/ 1654 w 2054"/>
              <a:gd name="T33" fmla="*/ 104 h 105"/>
              <a:gd name="T34" fmla="*/ 1759 w 2054"/>
              <a:gd name="T35" fmla="*/ 6 h 105"/>
              <a:gd name="T36" fmla="*/ 1863 w 2054"/>
              <a:gd name="T37" fmla="*/ 104 h 105"/>
              <a:gd name="T38" fmla="*/ 1967 w 2054"/>
              <a:gd name="T39" fmla="*/ 6 h 105"/>
              <a:gd name="T40" fmla="*/ 2054 w 2054"/>
              <a:gd name="T41" fmla="*/ 104 h 10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</a:cxnLst>
            <a:rect l="0" t="0" r="r" b="b"/>
            <a:pathLst>
              <a:path w="2054" h="105">
                <a:moveTo>
                  <a:pt x="0" y="102"/>
                </a:moveTo>
                <a:cubicBezTo>
                  <a:pt x="33" y="54"/>
                  <a:pt x="67" y="6"/>
                  <a:pt x="101" y="6"/>
                </a:cubicBezTo>
                <a:cubicBezTo>
                  <a:pt x="135" y="6"/>
                  <a:pt x="170" y="104"/>
                  <a:pt x="205" y="104"/>
                </a:cubicBezTo>
                <a:cubicBezTo>
                  <a:pt x="240" y="104"/>
                  <a:pt x="274" y="6"/>
                  <a:pt x="309" y="6"/>
                </a:cubicBezTo>
                <a:cubicBezTo>
                  <a:pt x="344" y="6"/>
                  <a:pt x="378" y="104"/>
                  <a:pt x="414" y="104"/>
                </a:cubicBezTo>
                <a:cubicBezTo>
                  <a:pt x="450" y="104"/>
                  <a:pt x="489" y="6"/>
                  <a:pt x="524" y="6"/>
                </a:cubicBezTo>
                <a:cubicBezTo>
                  <a:pt x="559" y="6"/>
                  <a:pt x="588" y="105"/>
                  <a:pt x="622" y="104"/>
                </a:cubicBezTo>
                <a:cubicBezTo>
                  <a:pt x="656" y="103"/>
                  <a:pt x="692" y="0"/>
                  <a:pt x="727" y="0"/>
                </a:cubicBezTo>
                <a:cubicBezTo>
                  <a:pt x="762" y="0"/>
                  <a:pt x="797" y="103"/>
                  <a:pt x="831" y="104"/>
                </a:cubicBezTo>
                <a:cubicBezTo>
                  <a:pt x="865" y="105"/>
                  <a:pt x="896" y="6"/>
                  <a:pt x="930" y="6"/>
                </a:cubicBezTo>
                <a:cubicBezTo>
                  <a:pt x="964" y="6"/>
                  <a:pt x="999" y="104"/>
                  <a:pt x="1034" y="104"/>
                </a:cubicBezTo>
                <a:cubicBezTo>
                  <a:pt x="1069" y="104"/>
                  <a:pt x="1103" y="6"/>
                  <a:pt x="1138" y="6"/>
                </a:cubicBezTo>
                <a:cubicBezTo>
                  <a:pt x="1173" y="6"/>
                  <a:pt x="1208" y="104"/>
                  <a:pt x="1243" y="104"/>
                </a:cubicBezTo>
                <a:cubicBezTo>
                  <a:pt x="1278" y="104"/>
                  <a:pt x="1312" y="6"/>
                  <a:pt x="1347" y="6"/>
                </a:cubicBezTo>
                <a:cubicBezTo>
                  <a:pt x="1382" y="6"/>
                  <a:pt x="1416" y="104"/>
                  <a:pt x="1451" y="104"/>
                </a:cubicBezTo>
                <a:cubicBezTo>
                  <a:pt x="1486" y="104"/>
                  <a:pt x="1522" y="6"/>
                  <a:pt x="1556" y="6"/>
                </a:cubicBezTo>
                <a:cubicBezTo>
                  <a:pt x="1590" y="6"/>
                  <a:pt x="1620" y="104"/>
                  <a:pt x="1654" y="104"/>
                </a:cubicBezTo>
                <a:cubicBezTo>
                  <a:pt x="1688" y="104"/>
                  <a:pt x="1724" y="6"/>
                  <a:pt x="1759" y="6"/>
                </a:cubicBezTo>
                <a:cubicBezTo>
                  <a:pt x="1794" y="6"/>
                  <a:pt x="1828" y="104"/>
                  <a:pt x="1863" y="104"/>
                </a:cubicBezTo>
                <a:cubicBezTo>
                  <a:pt x="1898" y="104"/>
                  <a:pt x="1935" y="6"/>
                  <a:pt x="1967" y="6"/>
                </a:cubicBezTo>
                <a:cubicBezTo>
                  <a:pt x="1999" y="6"/>
                  <a:pt x="2026" y="55"/>
                  <a:pt x="2054" y="104"/>
                </a:cubicBezTo>
              </a:path>
            </a:pathLst>
          </a:custGeom>
          <a:noFill/>
          <a:ln w="19050" cmpd="sng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bg1"/>
                </a:solidFill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>
              <a:solidFill>
                <a:srgbClr val="000000"/>
              </a:solidFill>
            </a:endParaRPr>
          </a:p>
        </p:txBody>
      </p:sp>
      <p:sp>
        <p:nvSpPr>
          <p:cNvPr id="250" name="Line 220"/>
          <p:cNvSpPr>
            <a:spLocks noChangeShapeType="1"/>
          </p:cNvSpPr>
          <p:nvPr/>
        </p:nvSpPr>
        <p:spPr bwMode="auto">
          <a:xfrm>
            <a:off x="2559392" y="7534193"/>
            <a:ext cx="0" cy="924800"/>
          </a:xfrm>
          <a:prstGeom prst="line">
            <a:avLst/>
          </a:prstGeom>
          <a:noFill/>
          <a:ln w="12700" cmpd="sng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r>
              <a:rPr lang="en-US" altLang="ja-JP" dirty="0">
                <a:solidFill>
                  <a:srgbClr val="000000"/>
                </a:solidFill>
              </a:rPr>
              <a:t> </a:t>
            </a:r>
            <a:endParaRPr lang="ja-JP" altLang="en-US" dirty="0">
              <a:solidFill>
                <a:srgbClr val="000000"/>
              </a:solidFill>
            </a:endParaRPr>
          </a:p>
        </p:txBody>
      </p:sp>
      <p:sp>
        <p:nvSpPr>
          <p:cNvPr id="251" name="Oval 272"/>
          <p:cNvSpPr>
            <a:spLocks noChangeArrowheads="1"/>
          </p:cNvSpPr>
          <p:nvPr/>
        </p:nvSpPr>
        <p:spPr bwMode="auto">
          <a:xfrm>
            <a:off x="2356497" y="7324484"/>
            <a:ext cx="391003" cy="185212"/>
          </a:xfrm>
          <a:prstGeom prst="ellipse">
            <a:avLst/>
          </a:prstGeom>
          <a:ln>
            <a:headEnd/>
            <a:tailEnd/>
          </a:ln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wrap="none" anchor="ctr"/>
          <a:lstStyle/>
          <a:p>
            <a:pPr algn="ctr"/>
            <a:r>
              <a:rPr lang="en-US" altLang="ja-JP" sz="900" dirty="0">
                <a:solidFill>
                  <a:srgbClr val="FFFFFF"/>
                </a:solidFill>
              </a:rPr>
              <a:t>Stat3</a:t>
            </a:r>
            <a:endParaRPr lang="ja-JP" altLang="ja-JP" sz="900" dirty="0">
              <a:solidFill>
                <a:srgbClr val="FFFFFF"/>
              </a:solidFill>
            </a:endParaRPr>
          </a:p>
        </p:txBody>
      </p:sp>
      <p:sp>
        <p:nvSpPr>
          <p:cNvPr id="252" name="Oval 274"/>
          <p:cNvSpPr>
            <a:spLocks noChangeArrowheads="1"/>
          </p:cNvSpPr>
          <p:nvPr/>
        </p:nvSpPr>
        <p:spPr bwMode="auto">
          <a:xfrm>
            <a:off x="1678000" y="7994428"/>
            <a:ext cx="489636" cy="182084"/>
          </a:xfrm>
          <a:prstGeom prst="ellipse">
            <a:avLst/>
          </a:prstGeom>
          <a:ln/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wrap="none" anchor="ctr"/>
          <a:lstStyle/>
          <a:p>
            <a:pPr algn="ctr"/>
            <a:r>
              <a:rPr lang="en-US" altLang="ja-JP" sz="900" dirty="0">
                <a:solidFill>
                  <a:schemeClr val="bg1"/>
                </a:solidFill>
                <a:latin typeface="Arial"/>
                <a:cs typeface="Arial"/>
              </a:rPr>
              <a:t>ATBF1</a:t>
            </a:r>
            <a:endParaRPr lang="ja-JP" altLang="ja-JP" sz="900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253" name="Freeform 275"/>
          <p:cNvSpPr>
            <a:spLocks/>
          </p:cNvSpPr>
          <p:nvPr/>
        </p:nvSpPr>
        <p:spPr bwMode="auto">
          <a:xfrm>
            <a:off x="3690855" y="7453581"/>
            <a:ext cx="124466" cy="75409"/>
          </a:xfrm>
          <a:custGeom>
            <a:avLst/>
            <a:gdLst>
              <a:gd name="T0" fmla="*/ 0 w 1872"/>
              <a:gd name="T1" fmla="*/ 128 h 1512"/>
              <a:gd name="T2" fmla="*/ 432 w 1872"/>
              <a:gd name="T3" fmla="*/ 128 h 1512"/>
              <a:gd name="T4" fmla="*/ 0 w 1872"/>
              <a:gd name="T5" fmla="*/ 896 h 1512"/>
              <a:gd name="T6" fmla="*/ 432 w 1872"/>
              <a:gd name="T7" fmla="*/ 1424 h 1512"/>
              <a:gd name="T8" fmla="*/ 1440 w 1872"/>
              <a:gd name="T9" fmla="*/ 1424 h 1512"/>
              <a:gd name="T10" fmla="*/ 1872 w 1872"/>
              <a:gd name="T11" fmla="*/ 896 h 1512"/>
              <a:gd name="T12" fmla="*/ 1440 w 1872"/>
              <a:gd name="T13" fmla="*/ 128 h 1512"/>
              <a:gd name="T14" fmla="*/ 1872 w 1872"/>
              <a:gd name="T15" fmla="*/ 128 h 15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1872" h="1512">
                <a:moveTo>
                  <a:pt x="0" y="128"/>
                </a:moveTo>
                <a:cubicBezTo>
                  <a:pt x="216" y="64"/>
                  <a:pt x="432" y="0"/>
                  <a:pt x="432" y="128"/>
                </a:cubicBezTo>
                <a:cubicBezTo>
                  <a:pt x="432" y="256"/>
                  <a:pt x="0" y="680"/>
                  <a:pt x="0" y="896"/>
                </a:cubicBezTo>
                <a:cubicBezTo>
                  <a:pt x="0" y="1112"/>
                  <a:pt x="192" y="1336"/>
                  <a:pt x="432" y="1424"/>
                </a:cubicBezTo>
                <a:cubicBezTo>
                  <a:pt x="672" y="1512"/>
                  <a:pt x="1200" y="1512"/>
                  <a:pt x="1440" y="1424"/>
                </a:cubicBezTo>
                <a:cubicBezTo>
                  <a:pt x="1680" y="1336"/>
                  <a:pt x="1872" y="1112"/>
                  <a:pt x="1872" y="896"/>
                </a:cubicBezTo>
                <a:cubicBezTo>
                  <a:pt x="1872" y="680"/>
                  <a:pt x="1440" y="256"/>
                  <a:pt x="1440" y="128"/>
                </a:cubicBezTo>
                <a:cubicBezTo>
                  <a:pt x="1440" y="0"/>
                  <a:pt x="1656" y="64"/>
                  <a:pt x="1872" y="128"/>
                </a:cubicBezTo>
              </a:path>
            </a:pathLst>
          </a:custGeom>
          <a:noFill/>
          <a:ln w="28575" cmpd="sng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>
              <a:solidFill>
                <a:srgbClr val="000000"/>
              </a:solidFill>
            </a:endParaRPr>
          </a:p>
        </p:txBody>
      </p:sp>
      <p:sp>
        <p:nvSpPr>
          <p:cNvPr id="254" name="Line 282"/>
          <p:cNvSpPr>
            <a:spLocks noChangeShapeType="1"/>
          </p:cNvSpPr>
          <p:nvPr/>
        </p:nvSpPr>
        <p:spPr bwMode="auto">
          <a:xfrm>
            <a:off x="3422755" y="7457953"/>
            <a:ext cx="268100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>
              <a:solidFill>
                <a:srgbClr val="000000"/>
              </a:solidFill>
            </a:endParaRPr>
          </a:p>
        </p:txBody>
      </p:sp>
      <p:sp>
        <p:nvSpPr>
          <p:cNvPr id="255" name="Text Box 288"/>
          <p:cNvSpPr txBox="1">
            <a:spLocks noChangeArrowheads="1"/>
          </p:cNvSpPr>
          <p:nvPr/>
        </p:nvSpPr>
        <p:spPr bwMode="auto">
          <a:xfrm>
            <a:off x="3635130" y="7277825"/>
            <a:ext cx="405852" cy="20005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76200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r>
              <a:rPr lang="en-US" altLang="ja-JP" sz="700" dirty="0">
                <a:solidFill>
                  <a:srgbClr val="000000"/>
                </a:solidFill>
                <a:latin typeface="Arial"/>
                <a:ea typeface="ＭＳ ゴシック" charset="0"/>
                <a:cs typeface="Arial"/>
              </a:rPr>
              <a:t>Zn</a:t>
            </a:r>
            <a:r>
              <a:rPr lang="en-US" altLang="ja-JP" sz="700" baseline="30000" dirty="0">
                <a:solidFill>
                  <a:srgbClr val="000000"/>
                </a:solidFill>
                <a:latin typeface="Arial"/>
                <a:ea typeface="ＭＳ ゴシック" charset="0"/>
                <a:cs typeface="Arial"/>
              </a:rPr>
              <a:t>2+</a:t>
            </a:r>
          </a:p>
        </p:txBody>
      </p:sp>
      <p:sp>
        <p:nvSpPr>
          <p:cNvPr id="256" name="Line 294"/>
          <p:cNvSpPr>
            <a:spLocks noChangeShapeType="1"/>
          </p:cNvSpPr>
          <p:nvPr/>
        </p:nvSpPr>
        <p:spPr bwMode="auto">
          <a:xfrm>
            <a:off x="3763803" y="8493919"/>
            <a:ext cx="274263" cy="0"/>
          </a:xfrm>
          <a:prstGeom prst="line">
            <a:avLst/>
          </a:prstGeom>
          <a:noFill/>
          <a:ln w="12700" cmpd="sng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>
              <a:solidFill>
                <a:srgbClr val="000000"/>
              </a:solidFill>
            </a:endParaRPr>
          </a:p>
        </p:txBody>
      </p:sp>
      <p:sp>
        <p:nvSpPr>
          <p:cNvPr id="257" name="Line 304"/>
          <p:cNvSpPr>
            <a:spLocks noChangeShapeType="1"/>
          </p:cNvSpPr>
          <p:nvPr/>
        </p:nvSpPr>
        <p:spPr bwMode="auto">
          <a:xfrm>
            <a:off x="3762593" y="7585869"/>
            <a:ext cx="0" cy="873124"/>
          </a:xfrm>
          <a:prstGeom prst="line">
            <a:avLst/>
          </a:prstGeom>
          <a:noFill/>
          <a:ln w="12700" cmpd="sng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>
              <a:solidFill>
                <a:srgbClr val="000000"/>
              </a:solidFill>
            </a:endParaRPr>
          </a:p>
        </p:txBody>
      </p:sp>
      <p:sp>
        <p:nvSpPr>
          <p:cNvPr id="258" name="Line 305"/>
          <p:cNvSpPr>
            <a:spLocks noChangeShapeType="1"/>
          </p:cNvSpPr>
          <p:nvPr/>
        </p:nvSpPr>
        <p:spPr bwMode="auto">
          <a:xfrm>
            <a:off x="3717723" y="8458994"/>
            <a:ext cx="91248" cy="0"/>
          </a:xfrm>
          <a:prstGeom prst="line">
            <a:avLst/>
          </a:prstGeom>
          <a:noFill/>
          <a:ln w="12700" cmpd="sng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>
              <a:solidFill>
                <a:srgbClr val="000000"/>
              </a:solidFill>
            </a:endParaRPr>
          </a:p>
        </p:txBody>
      </p:sp>
      <p:sp>
        <p:nvSpPr>
          <p:cNvPr id="259" name="Text Box 312"/>
          <p:cNvSpPr txBox="1">
            <a:spLocks noChangeArrowheads="1"/>
          </p:cNvSpPr>
          <p:nvPr/>
        </p:nvSpPr>
        <p:spPr bwMode="auto">
          <a:xfrm>
            <a:off x="3078061" y="6626417"/>
            <a:ext cx="431795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76200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ja-JP" sz="1000" dirty="0">
                <a:latin typeface="Arial"/>
                <a:ea typeface="ＭＳ ゴシック" charset="0"/>
                <a:cs typeface="Arial"/>
              </a:rPr>
              <a:t>Zn</a:t>
            </a:r>
            <a:r>
              <a:rPr lang="en-US" altLang="ja-JP" sz="1000" baseline="30000" dirty="0">
                <a:latin typeface="Arial"/>
                <a:ea typeface="ＭＳ ゴシック" charset="0"/>
                <a:cs typeface="Arial"/>
              </a:rPr>
              <a:t>2+</a:t>
            </a:r>
          </a:p>
        </p:txBody>
      </p:sp>
      <p:sp>
        <p:nvSpPr>
          <p:cNvPr id="260" name="Rectangle 313"/>
          <p:cNvSpPr>
            <a:spLocks noChangeArrowheads="1"/>
          </p:cNvSpPr>
          <p:nvPr/>
        </p:nvSpPr>
        <p:spPr bwMode="auto">
          <a:xfrm>
            <a:off x="2737793" y="6595848"/>
            <a:ext cx="477829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r>
              <a:rPr lang="en-US" altLang="ja-JP" sz="1000" dirty="0">
                <a:latin typeface="Arial"/>
                <a:ea typeface="ヒラギノ明朝 Pro W3" charset="0"/>
                <a:cs typeface="Arial"/>
              </a:rPr>
              <a:t>LIV1</a:t>
            </a:r>
            <a:endParaRPr lang="ja-JP" altLang="ja-JP" sz="1000" dirty="0">
              <a:latin typeface="Arial"/>
              <a:ea typeface="ヒラギノ明朝 Pro W3" charset="0"/>
              <a:cs typeface="Arial"/>
            </a:endParaRPr>
          </a:p>
        </p:txBody>
      </p:sp>
      <p:sp>
        <p:nvSpPr>
          <p:cNvPr id="261" name="Oval 322"/>
          <p:cNvSpPr>
            <a:spLocks noChangeArrowheads="1"/>
          </p:cNvSpPr>
          <p:nvPr/>
        </p:nvSpPr>
        <p:spPr bwMode="auto">
          <a:xfrm>
            <a:off x="1995121" y="8110086"/>
            <a:ext cx="390985" cy="147079"/>
          </a:xfrm>
          <a:prstGeom prst="ellipse">
            <a:avLst/>
          </a:prstGeom>
          <a:ln/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wrap="none" anchor="ctr"/>
          <a:lstStyle/>
          <a:p>
            <a:pPr algn="ctr"/>
            <a:r>
              <a:rPr lang="en-US" altLang="ja-JP" sz="900" dirty="0">
                <a:solidFill>
                  <a:schemeClr val="bg1"/>
                </a:solidFill>
                <a:latin typeface="Arial"/>
                <a:cs typeface="Arial"/>
              </a:rPr>
              <a:t>PIAS3</a:t>
            </a:r>
            <a:endParaRPr lang="ja-JP" altLang="ja-JP" sz="900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grpSp>
        <p:nvGrpSpPr>
          <p:cNvPr id="262" name="図形グループ 261"/>
          <p:cNvGrpSpPr/>
          <p:nvPr/>
        </p:nvGrpSpPr>
        <p:grpSpPr>
          <a:xfrm>
            <a:off x="4091299" y="6696402"/>
            <a:ext cx="28008" cy="364165"/>
            <a:chOff x="4755356" y="1423194"/>
            <a:chExt cx="43285" cy="562800"/>
          </a:xfrm>
        </p:grpSpPr>
        <p:sp>
          <p:nvSpPr>
            <p:cNvPr id="263" name="Oval 335"/>
            <p:cNvSpPr>
              <a:spLocks noChangeArrowheads="1"/>
            </p:cNvSpPr>
            <p:nvPr/>
          </p:nvSpPr>
          <p:spPr bwMode="auto">
            <a:xfrm>
              <a:off x="4755356" y="1423194"/>
              <a:ext cx="43285" cy="56280"/>
            </a:xfrm>
            <a:prstGeom prst="ellipse">
              <a:avLst/>
            </a:prstGeom>
            <a:solidFill>
              <a:schemeClr val="bg2"/>
            </a:solidFill>
            <a:ln w="19050" cmpd="sng">
              <a:solidFill>
                <a:srgbClr val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ja-JP" altLang="en-US"/>
            </a:p>
          </p:txBody>
        </p:sp>
        <p:sp>
          <p:nvSpPr>
            <p:cNvPr id="264" name="Oval 336"/>
            <p:cNvSpPr>
              <a:spLocks noChangeArrowheads="1"/>
            </p:cNvSpPr>
            <p:nvPr/>
          </p:nvSpPr>
          <p:spPr bwMode="auto">
            <a:xfrm>
              <a:off x="4755356" y="1507614"/>
              <a:ext cx="43285" cy="56280"/>
            </a:xfrm>
            <a:prstGeom prst="ellipse">
              <a:avLst/>
            </a:prstGeom>
            <a:solidFill>
              <a:schemeClr val="bg2"/>
            </a:solidFill>
            <a:ln w="19050" cmpd="sng">
              <a:solidFill>
                <a:srgbClr val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ja-JP" altLang="en-US"/>
            </a:p>
          </p:txBody>
        </p:sp>
        <p:sp>
          <p:nvSpPr>
            <p:cNvPr id="265" name="Oval 337"/>
            <p:cNvSpPr>
              <a:spLocks noChangeArrowheads="1"/>
            </p:cNvSpPr>
            <p:nvPr/>
          </p:nvSpPr>
          <p:spPr bwMode="auto">
            <a:xfrm>
              <a:off x="4755356" y="1592034"/>
              <a:ext cx="43285" cy="56280"/>
            </a:xfrm>
            <a:prstGeom prst="ellipse">
              <a:avLst/>
            </a:prstGeom>
            <a:solidFill>
              <a:schemeClr val="bg2"/>
            </a:solidFill>
            <a:ln w="19050" cmpd="sng">
              <a:solidFill>
                <a:srgbClr val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ja-JP" altLang="en-US"/>
            </a:p>
          </p:txBody>
        </p:sp>
        <p:sp>
          <p:nvSpPr>
            <p:cNvPr id="266" name="Oval 338"/>
            <p:cNvSpPr>
              <a:spLocks noChangeArrowheads="1"/>
            </p:cNvSpPr>
            <p:nvPr/>
          </p:nvSpPr>
          <p:spPr bwMode="auto">
            <a:xfrm>
              <a:off x="4755356" y="1676454"/>
              <a:ext cx="43285" cy="56280"/>
            </a:xfrm>
            <a:prstGeom prst="ellipse">
              <a:avLst/>
            </a:prstGeom>
            <a:solidFill>
              <a:schemeClr val="bg2"/>
            </a:solidFill>
            <a:ln w="19050" cmpd="sng">
              <a:solidFill>
                <a:srgbClr val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ja-JP" altLang="en-US"/>
            </a:p>
          </p:txBody>
        </p:sp>
        <p:sp>
          <p:nvSpPr>
            <p:cNvPr id="267" name="Oval 339"/>
            <p:cNvSpPr>
              <a:spLocks noChangeArrowheads="1"/>
            </p:cNvSpPr>
            <p:nvPr/>
          </p:nvSpPr>
          <p:spPr bwMode="auto">
            <a:xfrm>
              <a:off x="4755356" y="1760874"/>
              <a:ext cx="43285" cy="56280"/>
            </a:xfrm>
            <a:prstGeom prst="ellipse">
              <a:avLst/>
            </a:prstGeom>
            <a:solidFill>
              <a:schemeClr val="bg2"/>
            </a:solidFill>
            <a:ln w="19050" cmpd="sng">
              <a:solidFill>
                <a:srgbClr val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ja-JP" altLang="en-US"/>
            </a:p>
          </p:txBody>
        </p:sp>
        <p:sp>
          <p:nvSpPr>
            <p:cNvPr id="268" name="Line 340"/>
            <p:cNvSpPr>
              <a:spLocks noChangeShapeType="1"/>
            </p:cNvSpPr>
            <p:nvPr/>
          </p:nvSpPr>
          <p:spPr bwMode="auto">
            <a:xfrm>
              <a:off x="4776134" y="1423194"/>
              <a:ext cx="0" cy="562800"/>
            </a:xfrm>
            <a:prstGeom prst="line">
              <a:avLst/>
            </a:prstGeom>
            <a:noFill/>
            <a:ln w="19050" cmpd="sng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ja-JP" altLang="en-US"/>
            </a:p>
          </p:txBody>
        </p:sp>
      </p:grpSp>
      <p:sp>
        <p:nvSpPr>
          <p:cNvPr id="269" name="Text Box 372"/>
          <p:cNvSpPr txBox="1">
            <a:spLocks noChangeArrowheads="1"/>
          </p:cNvSpPr>
          <p:nvPr/>
        </p:nvSpPr>
        <p:spPr bwMode="auto">
          <a:xfrm>
            <a:off x="3201196" y="7237858"/>
            <a:ext cx="469825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ja-JP" sz="1000" dirty="0">
                <a:latin typeface="Arial"/>
                <a:ea typeface="ヒラギノ明朝 Pro W3" charset="0"/>
                <a:cs typeface="Arial"/>
              </a:rPr>
              <a:t>Snail </a:t>
            </a:r>
          </a:p>
        </p:txBody>
      </p:sp>
      <p:sp>
        <p:nvSpPr>
          <p:cNvPr id="270" name="円弧 269"/>
          <p:cNvSpPr/>
          <p:nvPr/>
        </p:nvSpPr>
        <p:spPr>
          <a:xfrm>
            <a:off x="3584809" y="7587798"/>
            <a:ext cx="64135" cy="56497"/>
          </a:xfrm>
          <a:prstGeom prst="arc">
            <a:avLst>
              <a:gd name="adj1" fmla="val 16200000"/>
              <a:gd name="adj2" fmla="val 5689821"/>
            </a:avLst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1" name="円弧 270"/>
          <p:cNvSpPr/>
          <p:nvPr/>
        </p:nvSpPr>
        <p:spPr>
          <a:xfrm flipH="1">
            <a:off x="2631413" y="7600276"/>
            <a:ext cx="64135" cy="56497"/>
          </a:xfrm>
          <a:prstGeom prst="arc">
            <a:avLst>
              <a:gd name="adj1" fmla="val 15775985"/>
              <a:gd name="adj2" fmla="val 5689821"/>
            </a:avLst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2" name="円弧 271"/>
          <p:cNvSpPr/>
          <p:nvPr/>
        </p:nvSpPr>
        <p:spPr>
          <a:xfrm>
            <a:off x="2376021" y="7629056"/>
            <a:ext cx="64135" cy="56497"/>
          </a:xfrm>
          <a:prstGeom prst="arc">
            <a:avLst>
              <a:gd name="adj1" fmla="val 15340642"/>
              <a:gd name="adj2" fmla="val 5689821"/>
            </a:avLst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3" name="円弧 272"/>
          <p:cNvSpPr/>
          <p:nvPr/>
        </p:nvSpPr>
        <p:spPr>
          <a:xfrm flipH="1">
            <a:off x="3824743" y="7632311"/>
            <a:ext cx="64135" cy="56497"/>
          </a:xfrm>
          <a:prstGeom prst="arc">
            <a:avLst>
              <a:gd name="adj1" fmla="val 15340642"/>
              <a:gd name="adj2" fmla="val 5689821"/>
            </a:avLst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274" name="図形グループ 273"/>
          <p:cNvGrpSpPr/>
          <p:nvPr/>
        </p:nvGrpSpPr>
        <p:grpSpPr>
          <a:xfrm>
            <a:off x="4146630" y="6696402"/>
            <a:ext cx="28008" cy="364165"/>
            <a:chOff x="4755356" y="1423194"/>
            <a:chExt cx="43285" cy="562800"/>
          </a:xfrm>
        </p:grpSpPr>
        <p:sp>
          <p:nvSpPr>
            <p:cNvPr id="275" name="Oval 335"/>
            <p:cNvSpPr>
              <a:spLocks noChangeArrowheads="1"/>
            </p:cNvSpPr>
            <p:nvPr/>
          </p:nvSpPr>
          <p:spPr bwMode="auto">
            <a:xfrm>
              <a:off x="4755356" y="1423194"/>
              <a:ext cx="43285" cy="56280"/>
            </a:xfrm>
            <a:prstGeom prst="ellipse">
              <a:avLst/>
            </a:prstGeom>
            <a:solidFill>
              <a:schemeClr val="bg2"/>
            </a:solidFill>
            <a:ln w="19050" cmpd="sng">
              <a:solidFill>
                <a:srgbClr val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ja-JP" altLang="en-US"/>
            </a:p>
          </p:txBody>
        </p:sp>
        <p:sp>
          <p:nvSpPr>
            <p:cNvPr id="276" name="Oval 336"/>
            <p:cNvSpPr>
              <a:spLocks noChangeArrowheads="1"/>
            </p:cNvSpPr>
            <p:nvPr/>
          </p:nvSpPr>
          <p:spPr bwMode="auto">
            <a:xfrm>
              <a:off x="4755356" y="1507614"/>
              <a:ext cx="43285" cy="56280"/>
            </a:xfrm>
            <a:prstGeom prst="ellipse">
              <a:avLst/>
            </a:prstGeom>
            <a:solidFill>
              <a:schemeClr val="bg2"/>
            </a:solidFill>
            <a:ln w="19050" cmpd="sng">
              <a:solidFill>
                <a:srgbClr val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ja-JP" altLang="en-US"/>
            </a:p>
          </p:txBody>
        </p:sp>
        <p:sp>
          <p:nvSpPr>
            <p:cNvPr id="277" name="Oval 337"/>
            <p:cNvSpPr>
              <a:spLocks noChangeArrowheads="1"/>
            </p:cNvSpPr>
            <p:nvPr/>
          </p:nvSpPr>
          <p:spPr bwMode="auto">
            <a:xfrm>
              <a:off x="4755356" y="1592034"/>
              <a:ext cx="43285" cy="56280"/>
            </a:xfrm>
            <a:prstGeom prst="ellipse">
              <a:avLst/>
            </a:prstGeom>
            <a:solidFill>
              <a:schemeClr val="bg2"/>
            </a:solidFill>
            <a:ln w="19050" cmpd="sng">
              <a:solidFill>
                <a:srgbClr val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ja-JP" altLang="en-US"/>
            </a:p>
          </p:txBody>
        </p:sp>
        <p:sp>
          <p:nvSpPr>
            <p:cNvPr id="278" name="Oval 338"/>
            <p:cNvSpPr>
              <a:spLocks noChangeArrowheads="1"/>
            </p:cNvSpPr>
            <p:nvPr/>
          </p:nvSpPr>
          <p:spPr bwMode="auto">
            <a:xfrm>
              <a:off x="4755356" y="1676454"/>
              <a:ext cx="43285" cy="56280"/>
            </a:xfrm>
            <a:prstGeom prst="ellipse">
              <a:avLst/>
            </a:prstGeom>
            <a:solidFill>
              <a:schemeClr val="bg2"/>
            </a:solidFill>
            <a:ln w="19050" cmpd="sng">
              <a:solidFill>
                <a:srgbClr val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ja-JP" altLang="en-US"/>
            </a:p>
          </p:txBody>
        </p:sp>
        <p:sp>
          <p:nvSpPr>
            <p:cNvPr id="279" name="Oval 339"/>
            <p:cNvSpPr>
              <a:spLocks noChangeArrowheads="1"/>
            </p:cNvSpPr>
            <p:nvPr/>
          </p:nvSpPr>
          <p:spPr bwMode="auto">
            <a:xfrm>
              <a:off x="4755356" y="1760874"/>
              <a:ext cx="43285" cy="56280"/>
            </a:xfrm>
            <a:prstGeom prst="ellipse">
              <a:avLst/>
            </a:prstGeom>
            <a:solidFill>
              <a:schemeClr val="bg2"/>
            </a:solidFill>
            <a:ln w="19050" cmpd="sng">
              <a:solidFill>
                <a:srgbClr val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ja-JP" altLang="en-US"/>
            </a:p>
          </p:txBody>
        </p:sp>
        <p:sp>
          <p:nvSpPr>
            <p:cNvPr id="280" name="Line 340"/>
            <p:cNvSpPr>
              <a:spLocks noChangeShapeType="1"/>
            </p:cNvSpPr>
            <p:nvPr/>
          </p:nvSpPr>
          <p:spPr bwMode="auto">
            <a:xfrm>
              <a:off x="4776134" y="1423194"/>
              <a:ext cx="0" cy="562800"/>
            </a:xfrm>
            <a:prstGeom prst="line">
              <a:avLst/>
            </a:prstGeom>
            <a:noFill/>
            <a:ln w="19050" cmpd="sng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ja-JP" altLang="en-US"/>
            </a:p>
          </p:txBody>
        </p:sp>
      </p:grpSp>
      <p:grpSp>
        <p:nvGrpSpPr>
          <p:cNvPr id="281" name="図形グループ 280"/>
          <p:cNvGrpSpPr/>
          <p:nvPr/>
        </p:nvGrpSpPr>
        <p:grpSpPr>
          <a:xfrm flipV="1">
            <a:off x="4206449" y="6423279"/>
            <a:ext cx="28008" cy="364165"/>
            <a:chOff x="4755356" y="1423194"/>
            <a:chExt cx="43285" cy="562800"/>
          </a:xfrm>
        </p:grpSpPr>
        <p:sp>
          <p:nvSpPr>
            <p:cNvPr id="282" name="Oval 335"/>
            <p:cNvSpPr>
              <a:spLocks noChangeArrowheads="1"/>
            </p:cNvSpPr>
            <p:nvPr/>
          </p:nvSpPr>
          <p:spPr bwMode="auto">
            <a:xfrm>
              <a:off x="4755356" y="1423194"/>
              <a:ext cx="43285" cy="56280"/>
            </a:xfrm>
            <a:prstGeom prst="ellipse">
              <a:avLst/>
            </a:prstGeom>
            <a:solidFill>
              <a:schemeClr val="bg2"/>
            </a:solidFill>
            <a:ln w="19050" cmpd="sng">
              <a:solidFill>
                <a:srgbClr val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ja-JP" altLang="en-US"/>
            </a:p>
          </p:txBody>
        </p:sp>
        <p:sp>
          <p:nvSpPr>
            <p:cNvPr id="283" name="Oval 336"/>
            <p:cNvSpPr>
              <a:spLocks noChangeArrowheads="1"/>
            </p:cNvSpPr>
            <p:nvPr/>
          </p:nvSpPr>
          <p:spPr bwMode="auto">
            <a:xfrm>
              <a:off x="4755356" y="1507614"/>
              <a:ext cx="43285" cy="56280"/>
            </a:xfrm>
            <a:prstGeom prst="ellipse">
              <a:avLst/>
            </a:prstGeom>
            <a:solidFill>
              <a:schemeClr val="bg2"/>
            </a:solidFill>
            <a:ln w="19050" cmpd="sng">
              <a:solidFill>
                <a:srgbClr val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ja-JP" altLang="en-US"/>
            </a:p>
          </p:txBody>
        </p:sp>
        <p:sp>
          <p:nvSpPr>
            <p:cNvPr id="284" name="Oval 337"/>
            <p:cNvSpPr>
              <a:spLocks noChangeArrowheads="1"/>
            </p:cNvSpPr>
            <p:nvPr/>
          </p:nvSpPr>
          <p:spPr bwMode="auto">
            <a:xfrm>
              <a:off x="4755356" y="1592034"/>
              <a:ext cx="43285" cy="56280"/>
            </a:xfrm>
            <a:prstGeom prst="ellipse">
              <a:avLst/>
            </a:prstGeom>
            <a:solidFill>
              <a:schemeClr val="bg2"/>
            </a:solidFill>
            <a:ln w="19050" cmpd="sng">
              <a:solidFill>
                <a:srgbClr val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ja-JP" altLang="en-US"/>
            </a:p>
          </p:txBody>
        </p:sp>
        <p:sp>
          <p:nvSpPr>
            <p:cNvPr id="285" name="Oval 338"/>
            <p:cNvSpPr>
              <a:spLocks noChangeArrowheads="1"/>
            </p:cNvSpPr>
            <p:nvPr/>
          </p:nvSpPr>
          <p:spPr bwMode="auto">
            <a:xfrm>
              <a:off x="4755356" y="1676454"/>
              <a:ext cx="43285" cy="56280"/>
            </a:xfrm>
            <a:prstGeom prst="ellipse">
              <a:avLst/>
            </a:prstGeom>
            <a:solidFill>
              <a:schemeClr val="bg2"/>
            </a:solidFill>
            <a:ln w="19050" cmpd="sng">
              <a:solidFill>
                <a:srgbClr val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ja-JP" altLang="en-US"/>
            </a:p>
          </p:txBody>
        </p:sp>
        <p:sp>
          <p:nvSpPr>
            <p:cNvPr id="286" name="Oval 339"/>
            <p:cNvSpPr>
              <a:spLocks noChangeArrowheads="1"/>
            </p:cNvSpPr>
            <p:nvPr/>
          </p:nvSpPr>
          <p:spPr bwMode="auto">
            <a:xfrm>
              <a:off x="4755356" y="1760874"/>
              <a:ext cx="43285" cy="56280"/>
            </a:xfrm>
            <a:prstGeom prst="ellipse">
              <a:avLst/>
            </a:prstGeom>
            <a:solidFill>
              <a:schemeClr val="bg2"/>
            </a:solidFill>
            <a:ln w="19050" cmpd="sng">
              <a:solidFill>
                <a:srgbClr val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ja-JP" altLang="en-US"/>
            </a:p>
          </p:txBody>
        </p:sp>
        <p:sp>
          <p:nvSpPr>
            <p:cNvPr id="287" name="Line 340"/>
            <p:cNvSpPr>
              <a:spLocks noChangeShapeType="1"/>
            </p:cNvSpPr>
            <p:nvPr/>
          </p:nvSpPr>
          <p:spPr bwMode="auto">
            <a:xfrm>
              <a:off x="4776134" y="1423194"/>
              <a:ext cx="0" cy="562800"/>
            </a:xfrm>
            <a:prstGeom prst="line">
              <a:avLst/>
            </a:prstGeom>
            <a:noFill/>
            <a:ln w="19050" cmpd="sng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ja-JP" altLang="en-US"/>
            </a:p>
          </p:txBody>
        </p:sp>
      </p:grpSp>
      <p:grpSp>
        <p:nvGrpSpPr>
          <p:cNvPr id="288" name="図形グループ 287"/>
          <p:cNvGrpSpPr/>
          <p:nvPr/>
        </p:nvGrpSpPr>
        <p:grpSpPr>
          <a:xfrm flipV="1">
            <a:off x="4256028" y="6423279"/>
            <a:ext cx="28008" cy="364165"/>
            <a:chOff x="4755356" y="1423194"/>
            <a:chExt cx="43285" cy="562800"/>
          </a:xfrm>
        </p:grpSpPr>
        <p:sp>
          <p:nvSpPr>
            <p:cNvPr id="289" name="Oval 335"/>
            <p:cNvSpPr>
              <a:spLocks noChangeArrowheads="1"/>
            </p:cNvSpPr>
            <p:nvPr/>
          </p:nvSpPr>
          <p:spPr bwMode="auto">
            <a:xfrm>
              <a:off x="4755356" y="1423194"/>
              <a:ext cx="43285" cy="56280"/>
            </a:xfrm>
            <a:prstGeom prst="ellipse">
              <a:avLst/>
            </a:prstGeom>
            <a:solidFill>
              <a:schemeClr val="bg2"/>
            </a:solidFill>
            <a:ln w="19050" cmpd="sng">
              <a:solidFill>
                <a:srgbClr val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ja-JP" altLang="en-US"/>
            </a:p>
          </p:txBody>
        </p:sp>
        <p:sp>
          <p:nvSpPr>
            <p:cNvPr id="290" name="Oval 336"/>
            <p:cNvSpPr>
              <a:spLocks noChangeArrowheads="1"/>
            </p:cNvSpPr>
            <p:nvPr/>
          </p:nvSpPr>
          <p:spPr bwMode="auto">
            <a:xfrm>
              <a:off x="4755356" y="1507614"/>
              <a:ext cx="43285" cy="56280"/>
            </a:xfrm>
            <a:prstGeom prst="ellipse">
              <a:avLst/>
            </a:prstGeom>
            <a:solidFill>
              <a:schemeClr val="bg2"/>
            </a:solidFill>
            <a:ln w="19050" cmpd="sng">
              <a:solidFill>
                <a:srgbClr val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ja-JP" altLang="en-US"/>
            </a:p>
          </p:txBody>
        </p:sp>
        <p:sp>
          <p:nvSpPr>
            <p:cNvPr id="291" name="Oval 337"/>
            <p:cNvSpPr>
              <a:spLocks noChangeArrowheads="1"/>
            </p:cNvSpPr>
            <p:nvPr/>
          </p:nvSpPr>
          <p:spPr bwMode="auto">
            <a:xfrm>
              <a:off x="4755356" y="1592034"/>
              <a:ext cx="43285" cy="56280"/>
            </a:xfrm>
            <a:prstGeom prst="ellipse">
              <a:avLst/>
            </a:prstGeom>
            <a:solidFill>
              <a:schemeClr val="bg2"/>
            </a:solidFill>
            <a:ln w="19050" cmpd="sng">
              <a:solidFill>
                <a:srgbClr val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ja-JP" altLang="en-US"/>
            </a:p>
          </p:txBody>
        </p:sp>
        <p:sp>
          <p:nvSpPr>
            <p:cNvPr id="292" name="Oval 338"/>
            <p:cNvSpPr>
              <a:spLocks noChangeArrowheads="1"/>
            </p:cNvSpPr>
            <p:nvPr/>
          </p:nvSpPr>
          <p:spPr bwMode="auto">
            <a:xfrm>
              <a:off x="4755356" y="1676454"/>
              <a:ext cx="43285" cy="56280"/>
            </a:xfrm>
            <a:prstGeom prst="ellipse">
              <a:avLst/>
            </a:prstGeom>
            <a:solidFill>
              <a:schemeClr val="bg2"/>
            </a:solidFill>
            <a:ln w="19050" cmpd="sng">
              <a:solidFill>
                <a:srgbClr val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ja-JP" altLang="en-US"/>
            </a:p>
          </p:txBody>
        </p:sp>
        <p:sp>
          <p:nvSpPr>
            <p:cNvPr id="293" name="Oval 339"/>
            <p:cNvSpPr>
              <a:spLocks noChangeArrowheads="1"/>
            </p:cNvSpPr>
            <p:nvPr/>
          </p:nvSpPr>
          <p:spPr bwMode="auto">
            <a:xfrm>
              <a:off x="4755356" y="1760874"/>
              <a:ext cx="43285" cy="56280"/>
            </a:xfrm>
            <a:prstGeom prst="ellipse">
              <a:avLst/>
            </a:prstGeom>
            <a:solidFill>
              <a:schemeClr val="bg2"/>
            </a:solidFill>
            <a:ln w="19050" cmpd="sng">
              <a:solidFill>
                <a:srgbClr val="000000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ja-JP" altLang="en-US"/>
            </a:p>
          </p:txBody>
        </p:sp>
        <p:sp>
          <p:nvSpPr>
            <p:cNvPr id="294" name="Line 340"/>
            <p:cNvSpPr>
              <a:spLocks noChangeShapeType="1"/>
            </p:cNvSpPr>
            <p:nvPr/>
          </p:nvSpPr>
          <p:spPr bwMode="auto">
            <a:xfrm>
              <a:off x="4776134" y="1423194"/>
              <a:ext cx="0" cy="562800"/>
            </a:xfrm>
            <a:prstGeom prst="line">
              <a:avLst/>
            </a:prstGeom>
            <a:noFill/>
            <a:ln w="19050" cmpd="sng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ja-JP" altLang="en-US"/>
            </a:p>
          </p:txBody>
        </p:sp>
      </p:grpSp>
      <p:cxnSp>
        <p:nvCxnSpPr>
          <p:cNvPr id="295" name="直線コネクタ 294"/>
          <p:cNvCxnSpPr/>
          <p:nvPr/>
        </p:nvCxnSpPr>
        <p:spPr>
          <a:xfrm>
            <a:off x="4047256" y="6463201"/>
            <a:ext cx="385074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6" name="直線コネクタ 295"/>
          <p:cNvCxnSpPr/>
          <p:nvPr/>
        </p:nvCxnSpPr>
        <p:spPr>
          <a:xfrm>
            <a:off x="4047256" y="6504974"/>
            <a:ext cx="385074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7" name="Text Box 372"/>
          <p:cNvSpPr txBox="1">
            <a:spLocks noChangeArrowheads="1"/>
          </p:cNvSpPr>
          <p:nvPr/>
        </p:nvSpPr>
        <p:spPr bwMode="auto">
          <a:xfrm>
            <a:off x="2551999" y="8308669"/>
            <a:ext cx="478395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ja-JP" sz="1000" i="1" dirty="0">
                <a:latin typeface="Arial"/>
                <a:ea typeface="ヒラギノ明朝 Pro W3" charset="0"/>
                <a:cs typeface="Arial"/>
              </a:rPr>
              <a:t>LIV1 </a:t>
            </a:r>
          </a:p>
        </p:txBody>
      </p:sp>
      <p:sp>
        <p:nvSpPr>
          <p:cNvPr id="298" name="Freeform 275"/>
          <p:cNvSpPr>
            <a:spLocks/>
          </p:cNvSpPr>
          <p:nvPr/>
        </p:nvSpPr>
        <p:spPr bwMode="auto">
          <a:xfrm>
            <a:off x="3903444" y="7453581"/>
            <a:ext cx="110110" cy="85257"/>
          </a:xfrm>
          <a:custGeom>
            <a:avLst/>
            <a:gdLst>
              <a:gd name="T0" fmla="*/ 0 w 1872"/>
              <a:gd name="T1" fmla="*/ 128 h 1512"/>
              <a:gd name="T2" fmla="*/ 432 w 1872"/>
              <a:gd name="T3" fmla="*/ 128 h 1512"/>
              <a:gd name="T4" fmla="*/ 0 w 1872"/>
              <a:gd name="T5" fmla="*/ 896 h 1512"/>
              <a:gd name="T6" fmla="*/ 432 w 1872"/>
              <a:gd name="T7" fmla="*/ 1424 h 1512"/>
              <a:gd name="T8" fmla="*/ 1440 w 1872"/>
              <a:gd name="T9" fmla="*/ 1424 h 1512"/>
              <a:gd name="T10" fmla="*/ 1872 w 1872"/>
              <a:gd name="T11" fmla="*/ 896 h 1512"/>
              <a:gd name="T12" fmla="*/ 1440 w 1872"/>
              <a:gd name="T13" fmla="*/ 128 h 1512"/>
              <a:gd name="T14" fmla="*/ 1872 w 1872"/>
              <a:gd name="T15" fmla="*/ 128 h 15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1872" h="1512">
                <a:moveTo>
                  <a:pt x="0" y="128"/>
                </a:moveTo>
                <a:cubicBezTo>
                  <a:pt x="216" y="64"/>
                  <a:pt x="432" y="0"/>
                  <a:pt x="432" y="128"/>
                </a:cubicBezTo>
                <a:cubicBezTo>
                  <a:pt x="432" y="256"/>
                  <a:pt x="0" y="680"/>
                  <a:pt x="0" y="896"/>
                </a:cubicBezTo>
                <a:cubicBezTo>
                  <a:pt x="0" y="1112"/>
                  <a:pt x="192" y="1336"/>
                  <a:pt x="432" y="1424"/>
                </a:cubicBezTo>
                <a:cubicBezTo>
                  <a:pt x="672" y="1512"/>
                  <a:pt x="1200" y="1512"/>
                  <a:pt x="1440" y="1424"/>
                </a:cubicBezTo>
                <a:cubicBezTo>
                  <a:pt x="1680" y="1336"/>
                  <a:pt x="1872" y="1112"/>
                  <a:pt x="1872" y="896"/>
                </a:cubicBezTo>
                <a:cubicBezTo>
                  <a:pt x="1872" y="680"/>
                  <a:pt x="1440" y="256"/>
                  <a:pt x="1440" y="128"/>
                </a:cubicBezTo>
                <a:cubicBezTo>
                  <a:pt x="1440" y="0"/>
                  <a:pt x="1656" y="64"/>
                  <a:pt x="1872" y="128"/>
                </a:cubicBezTo>
              </a:path>
            </a:pathLst>
          </a:custGeom>
          <a:noFill/>
          <a:ln w="28575" cmpd="sng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>
              <a:solidFill>
                <a:srgbClr val="000000"/>
              </a:solidFill>
            </a:endParaRPr>
          </a:p>
        </p:txBody>
      </p:sp>
      <p:sp>
        <p:nvSpPr>
          <p:cNvPr id="299" name="Text Box 288"/>
          <p:cNvSpPr txBox="1">
            <a:spLocks noChangeArrowheads="1"/>
          </p:cNvSpPr>
          <p:nvPr/>
        </p:nvSpPr>
        <p:spPr bwMode="auto">
          <a:xfrm>
            <a:off x="3845896" y="7274806"/>
            <a:ext cx="392157" cy="20005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76200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r>
              <a:rPr lang="en-US" altLang="ja-JP" sz="700" dirty="0">
                <a:solidFill>
                  <a:srgbClr val="000000"/>
                </a:solidFill>
                <a:latin typeface="Arial"/>
                <a:ea typeface="ＭＳ ゴシック" charset="0"/>
                <a:cs typeface="Arial"/>
              </a:rPr>
              <a:t>Zn</a:t>
            </a:r>
            <a:r>
              <a:rPr lang="en-US" altLang="ja-JP" sz="700" baseline="30000" dirty="0">
                <a:solidFill>
                  <a:srgbClr val="000000"/>
                </a:solidFill>
                <a:latin typeface="Arial"/>
                <a:ea typeface="ＭＳ ゴシック" charset="0"/>
                <a:cs typeface="Arial"/>
              </a:rPr>
              <a:t>2+</a:t>
            </a:r>
          </a:p>
        </p:txBody>
      </p:sp>
      <p:sp>
        <p:nvSpPr>
          <p:cNvPr id="300" name="Freeform 275"/>
          <p:cNvSpPr>
            <a:spLocks/>
          </p:cNvSpPr>
          <p:nvPr/>
        </p:nvSpPr>
        <p:spPr bwMode="auto">
          <a:xfrm>
            <a:off x="4108771" y="7453581"/>
            <a:ext cx="113075" cy="75015"/>
          </a:xfrm>
          <a:custGeom>
            <a:avLst/>
            <a:gdLst>
              <a:gd name="T0" fmla="*/ 0 w 1872"/>
              <a:gd name="T1" fmla="*/ 128 h 1512"/>
              <a:gd name="T2" fmla="*/ 432 w 1872"/>
              <a:gd name="T3" fmla="*/ 128 h 1512"/>
              <a:gd name="T4" fmla="*/ 0 w 1872"/>
              <a:gd name="T5" fmla="*/ 896 h 1512"/>
              <a:gd name="T6" fmla="*/ 432 w 1872"/>
              <a:gd name="T7" fmla="*/ 1424 h 1512"/>
              <a:gd name="T8" fmla="*/ 1440 w 1872"/>
              <a:gd name="T9" fmla="*/ 1424 h 1512"/>
              <a:gd name="T10" fmla="*/ 1872 w 1872"/>
              <a:gd name="T11" fmla="*/ 896 h 1512"/>
              <a:gd name="T12" fmla="*/ 1440 w 1872"/>
              <a:gd name="T13" fmla="*/ 128 h 1512"/>
              <a:gd name="T14" fmla="*/ 1872 w 1872"/>
              <a:gd name="T15" fmla="*/ 128 h 15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1872" h="1512">
                <a:moveTo>
                  <a:pt x="0" y="128"/>
                </a:moveTo>
                <a:cubicBezTo>
                  <a:pt x="216" y="64"/>
                  <a:pt x="432" y="0"/>
                  <a:pt x="432" y="128"/>
                </a:cubicBezTo>
                <a:cubicBezTo>
                  <a:pt x="432" y="256"/>
                  <a:pt x="0" y="680"/>
                  <a:pt x="0" y="896"/>
                </a:cubicBezTo>
                <a:cubicBezTo>
                  <a:pt x="0" y="1112"/>
                  <a:pt x="192" y="1336"/>
                  <a:pt x="432" y="1424"/>
                </a:cubicBezTo>
                <a:cubicBezTo>
                  <a:pt x="672" y="1512"/>
                  <a:pt x="1200" y="1512"/>
                  <a:pt x="1440" y="1424"/>
                </a:cubicBezTo>
                <a:cubicBezTo>
                  <a:pt x="1680" y="1336"/>
                  <a:pt x="1872" y="1112"/>
                  <a:pt x="1872" y="896"/>
                </a:cubicBezTo>
                <a:cubicBezTo>
                  <a:pt x="1872" y="680"/>
                  <a:pt x="1440" y="256"/>
                  <a:pt x="1440" y="128"/>
                </a:cubicBezTo>
                <a:cubicBezTo>
                  <a:pt x="1440" y="0"/>
                  <a:pt x="1656" y="64"/>
                  <a:pt x="1872" y="128"/>
                </a:cubicBezTo>
              </a:path>
            </a:pathLst>
          </a:custGeom>
          <a:noFill/>
          <a:ln w="28575" cmpd="sng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>
              <a:solidFill>
                <a:srgbClr val="000000"/>
              </a:solidFill>
            </a:endParaRPr>
          </a:p>
        </p:txBody>
      </p:sp>
      <p:sp>
        <p:nvSpPr>
          <p:cNvPr id="301" name="Text Box 288"/>
          <p:cNvSpPr txBox="1">
            <a:spLocks noChangeArrowheads="1"/>
          </p:cNvSpPr>
          <p:nvPr/>
        </p:nvSpPr>
        <p:spPr bwMode="auto">
          <a:xfrm>
            <a:off x="4038619" y="7274490"/>
            <a:ext cx="403727" cy="20005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76200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r>
              <a:rPr lang="en-US" altLang="ja-JP" sz="700" dirty="0">
                <a:solidFill>
                  <a:srgbClr val="000000"/>
                </a:solidFill>
                <a:latin typeface="Arial"/>
                <a:ea typeface="ＭＳ ゴシック" charset="0"/>
                <a:cs typeface="Arial"/>
              </a:rPr>
              <a:t>Zn</a:t>
            </a:r>
            <a:r>
              <a:rPr lang="en-US" altLang="ja-JP" sz="700" baseline="30000" dirty="0">
                <a:solidFill>
                  <a:srgbClr val="000000"/>
                </a:solidFill>
                <a:latin typeface="Arial"/>
                <a:ea typeface="ＭＳ ゴシック" charset="0"/>
                <a:cs typeface="Arial"/>
              </a:rPr>
              <a:t>2+</a:t>
            </a:r>
          </a:p>
        </p:txBody>
      </p:sp>
      <p:sp>
        <p:nvSpPr>
          <p:cNvPr id="302" name="Freeform 275"/>
          <p:cNvSpPr>
            <a:spLocks/>
          </p:cNvSpPr>
          <p:nvPr/>
        </p:nvSpPr>
        <p:spPr bwMode="auto">
          <a:xfrm>
            <a:off x="4318948" y="7453581"/>
            <a:ext cx="122195" cy="85310"/>
          </a:xfrm>
          <a:custGeom>
            <a:avLst/>
            <a:gdLst>
              <a:gd name="T0" fmla="*/ 0 w 1872"/>
              <a:gd name="T1" fmla="*/ 128 h 1512"/>
              <a:gd name="T2" fmla="*/ 432 w 1872"/>
              <a:gd name="T3" fmla="*/ 128 h 1512"/>
              <a:gd name="T4" fmla="*/ 0 w 1872"/>
              <a:gd name="T5" fmla="*/ 896 h 1512"/>
              <a:gd name="T6" fmla="*/ 432 w 1872"/>
              <a:gd name="T7" fmla="*/ 1424 h 1512"/>
              <a:gd name="T8" fmla="*/ 1440 w 1872"/>
              <a:gd name="T9" fmla="*/ 1424 h 1512"/>
              <a:gd name="T10" fmla="*/ 1872 w 1872"/>
              <a:gd name="T11" fmla="*/ 896 h 1512"/>
              <a:gd name="T12" fmla="*/ 1440 w 1872"/>
              <a:gd name="T13" fmla="*/ 128 h 1512"/>
              <a:gd name="T14" fmla="*/ 1872 w 1872"/>
              <a:gd name="T15" fmla="*/ 128 h 15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1872" h="1512">
                <a:moveTo>
                  <a:pt x="0" y="128"/>
                </a:moveTo>
                <a:cubicBezTo>
                  <a:pt x="216" y="64"/>
                  <a:pt x="432" y="0"/>
                  <a:pt x="432" y="128"/>
                </a:cubicBezTo>
                <a:cubicBezTo>
                  <a:pt x="432" y="256"/>
                  <a:pt x="0" y="680"/>
                  <a:pt x="0" y="896"/>
                </a:cubicBezTo>
                <a:cubicBezTo>
                  <a:pt x="0" y="1112"/>
                  <a:pt x="192" y="1336"/>
                  <a:pt x="432" y="1424"/>
                </a:cubicBezTo>
                <a:cubicBezTo>
                  <a:pt x="672" y="1512"/>
                  <a:pt x="1200" y="1512"/>
                  <a:pt x="1440" y="1424"/>
                </a:cubicBezTo>
                <a:cubicBezTo>
                  <a:pt x="1680" y="1336"/>
                  <a:pt x="1872" y="1112"/>
                  <a:pt x="1872" y="896"/>
                </a:cubicBezTo>
                <a:cubicBezTo>
                  <a:pt x="1872" y="680"/>
                  <a:pt x="1440" y="256"/>
                  <a:pt x="1440" y="128"/>
                </a:cubicBezTo>
                <a:cubicBezTo>
                  <a:pt x="1440" y="0"/>
                  <a:pt x="1656" y="64"/>
                  <a:pt x="1872" y="128"/>
                </a:cubicBezTo>
              </a:path>
            </a:pathLst>
          </a:custGeom>
          <a:noFill/>
          <a:ln w="28575" cmpd="sng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>
              <a:solidFill>
                <a:srgbClr val="000000"/>
              </a:solidFill>
            </a:endParaRPr>
          </a:p>
        </p:txBody>
      </p:sp>
      <p:sp>
        <p:nvSpPr>
          <p:cNvPr id="303" name="Text Box 288"/>
          <p:cNvSpPr txBox="1">
            <a:spLocks noChangeArrowheads="1"/>
          </p:cNvSpPr>
          <p:nvPr/>
        </p:nvSpPr>
        <p:spPr bwMode="auto">
          <a:xfrm>
            <a:off x="4254636" y="7274753"/>
            <a:ext cx="434813" cy="20005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76200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r>
              <a:rPr lang="en-US" altLang="ja-JP" sz="700" dirty="0">
                <a:solidFill>
                  <a:srgbClr val="000000"/>
                </a:solidFill>
                <a:latin typeface="Arial"/>
                <a:ea typeface="ＭＳ ゴシック" charset="0"/>
                <a:cs typeface="Arial"/>
              </a:rPr>
              <a:t>Zn</a:t>
            </a:r>
            <a:r>
              <a:rPr lang="en-US" altLang="ja-JP" sz="700" baseline="30000" dirty="0">
                <a:solidFill>
                  <a:srgbClr val="000000"/>
                </a:solidFill>
                <a:latin typeface="Arial"/>
                <a:ea typeface="ＭＳ ゴシック" charset="0"/>
                <a:cs typeface="Arial"/>
              </a:rPr>
              <a:t>2+</a:t>
            </a:r>
          </a:p>
        </p:txBody>
      </p:sp>
      <p:sp>
        <p:nvSpPr>
          <p:cNvPr id="304" name="Line 282"/>
          <p:cNvSpPr>
            <a:spLocks noChangeShapeType="1"/>
          </p:cNvSpPr>
          <p:nvPr/>
        </p:nvSpPr>
        <p:spPr bwMode="auto">
          <a:xfrm>
            <a:off x="4219423" y="7457469"/>
            <a:ext cx="99524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>
              <a:solidFill>
                <a:srgbClr val="000000"/>
              </a:solidFill>
            </a:endParaRPr>
          </a:p>
        </p:txBody>
      </p:sp>
      <p:cxnSp>
        <p:nvCxnSpPr>
          <p:cNvPr id="305" name="直線コネクタ 304"/>
          <p:cNvCxnSpPr/>
          <p:nvPr/>
        </p:nvCxnSpPr>
        <p:spPr>
          <a:xfrm>
            <a:off x="1728074" y="6971259"/>
            <a:ext cx="2728723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6" name="直線コネクタ 305"/>
          <p:cNvCxnSpPr/>
          <p:nvPr/>
        </p:nvCxnSpPr>
        <p:spPr>
          <a:xfrm>
            <a:off x="1728074" y="7019879"/>
            <a:ext cx="2728723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7" name="Freeform 330"/>
          <p:cNvSpPr>
            <a:spLocks/>
          </p:cNvSpPr>
          <p:nvPr/>
        </p:nvSpPr>
        <p:spPr bwMode="auto">
          <a:xfrm>
            <a:off x="2828748" y="6846675"/>
            <a:ext cx="349366" cy="370710"/>
          </a:xfrm>
          <a:custGeom>
            <a:avLst/>
            <a:gdLst>
              <a:gd name="T0" fmla="*/ 1616 w 1616"/>
              <a:gd name="T1" fmla="*/ 72 h 1760"/>
              <a:gd name="T2" fmla="*/ 1232 w 1616"/>
              <a:gd name="T3" fmla="*/ 72 h 1760"/>
              <a:gd name="T4" fmla="*/ 512 w 1616"/>
              <a:gd name="T5" fmla="*/ 72 h 1760"/>
              <a:gd name="T6" fmla="*/ 80 w 1616"/>
              <a:gd name="T7" fmla="*/ 168 h 1760"/>
              <a:gd name="T8" fmla="*/ 32 w 1616"/>
              <a:gd name="T9" fmla="*/ 1080 h 1760"/>
              <a:gd name="T10" fmla="*/ 176 w 1616"/>
              <a:gd name="T11" fmla="*/ 1080 h 1760"/>
              <a:gd name="T12" fmla="*/ 176 w 1616"/>
              <a:gd name="T13" fmla="*/ 552 h 1760"/>
              <a:gd name="T14" fmla="*/ 368 w 1616"/>
              <a:gd name="T15" fmla="*/ 504 h 1760"/>
              <a:gd name="T16" fmla="*/ 368 w 1616"/>
              <a:gd name="T17" fmla="*/ 1080 h 1760"/>
              <a:gd name="T18" fmla="*/ 368 w 1616"/>
              <a:gd name="T19" fmla="*/ 1368 h 1760"/>
              <a:gd name="T20" fmla="*/ 80 w 1616"/>
              <a:gd name="T21" fmla="*/ 1512 h 1760"/>
              <a:gd name="T22" fmla="*/ 176 w 1616"/>
              <a:gd name="T23" fmla="*/ 1752 h 1760"/>
              <a:gd name="T24" fmla="*/ 416 w 1616"/>
              <a:gd name="T25" fmla="*/ 1560 h 1760"/>
              <a:gd name="T26" fmla="*/ 656 w 1616"/>
              <a:gd name="T27" fmla="*/ 1752 h 1760"/>
              <a:gd name="T28" fmla="*/ 848 w 1616"/>
              <a:gd name="T29" fmla="*/ 1512 h 1760"/>
              <a:gd name="T30" fmla="*/ 560 w 1616"/>
              <a:gd name="T31" fmla="*/ 1320 h 1760"/>
              <a:gd name="T32" fmla="*/ 560 w 1616"/>
              <a:gd name="T33" fmla="*/ 504 h 1760"/>
              <a:gd name="T34" fmla="*/ 752 w 1616"/>
              <a:gd name="T35" fmla="*/ 456 h 1760"/>
              <a:gd name="T36" fmla="*/ 704 w 1616"/>
              <a:gd name="T37" fmla="*/ 1128 h 1760"/>
              <a:gd name="T38" fmla="*/ 800 w 1616"/>
              <a:gd name="T39" fmla="*/ 1272 h 1760"/>
              <a:gd name="T40" fmla="*/ 944 w 1616"/>
              <a:gd name="T41" fmla="*/ 1176 h 1760"/>
              <a:gd name="T42" fmla="*/ 944 w 1616"/>
              <a:gd name="T43" fmla="*/ 456 h 1760"/>
              <a:gd name="T44" fmla="*/ 1088 w 1616"/>
              <a:gd name="T45" fmla="*/ 360 h 1760"/>
              <a:gd name="T46" fmla="*/ 1136 w 1616"/>
              <a:gd name="T47" fmla="*/ 936 h 1760"/>
              <a:gd name="T48" fmla="*/ 1088 w 1616"/>
              <a:gd name="T49" fmla="*/ 1272 h 1760"/>
              <a:gd name="T50" fmla="*/ 1328 w 1616"/>
              <a:gd name="T51" fmla="*/ 1224 h 1760"/>
              <a:gd name="T52" fmla="*/ 1328 w 1616"/>
              <a:gd name="T53" fmla="*/ 504 h 1760"/>
              <a:gd name="T54" fmla="*/ 1376 w 1616"/>
              <a:gd name="T55" fmla="*/ 360 h 1760"/>
              <a:gd name="T56" fmla="*/ 1616 w 1616"/>
              <a:gd name="T57" fmla="*/ 360 h 17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</a:cxnLst>
            <a:rect l="0" t="0" r="r" b="b"/>
            <a:pathLst>
              <a:path w="1616" h="1760">
                <a:moveTo>
                  <a:pt x="1616" y="72"/>
                </a:moveTo>
                <a:cubicBezTo>
                  <a:pt x="1516" y="72"/>
                  <a:pt x="1416" y="72"/>
                  <a:pt x="1232" y="72"/>
                </a:cubicBezTo>
                <a:cubicBezTo>
                  <a:pt x="1048" y="72"/>
                  <a:pt x="704" y="56"/>
                  <a:pt x="512" y="72"/>
                </a:cubicBezTo>
                <a:cubicBezTo>
                  <a:pt x="320" y="88"/>
                  <a:pt x="160" y="0"/>
                  <a:pt x="80" y="168"/>
                </a:cubicBezTo>
                <a:cubicBezTo>
                  <a:pt x="0" y="336"/>
                  <a:pt x="16" y="928"/>
                  <a:pt x="32" y="1080"/>
                </a:cubicBezTo>
                <a:cubicBezTo>
                  <a:pt x="48" y="1232"/>
                  <a:pt x="152" y="1168"/>
                  <a:pt x="176" y="1080"/>
                </a:cubicBezTo>
                <a:cubicBezTo>
                  <a:pt x="200" y="992"/>
                  <a:pt x="144" y="648"/>
                  <a:pt x="176" y="552"/>
                </a:cubicBezTo>
                <a:cubicBezTo>
                  <a:pt x="208" y="456"/>
                  <a:pt x="336" y="416"/>
                  <a:pt x="368" y="504"/>
                </a:cubicBezTo>
                <a:cubicBezTo>
                  <a:pt x="400" y="592"/>
                  <a:pt x="368" y="936"/>
                  <a:pt x="368" y="1080"/>
                </a:cubicBezTo>
                <a:cubicBezTo>
                  <a:pt x="368" y="1224"/>
                  <a:pt x="416" y="1296"/>
                  <a:pt x="368" y="1368"/>
                </a:cubicBezTo>
                <a:cubicBezTo>
                  <a:pt x="320" y="1440"/>
                  <a:pt x="112" y="1448"/>
                  <a:pt x="80" y="1512"/>
                </a:cubicBezTo>
                <a:cubicBezTo>
                  <a:pt x="48" y="1576"/>
                  <a:pt x="120" y="1744"/>
                  <a:pt x="176" y="1752"/>
                </a:cubicBezTo>
                <a:cubicBezTo>
                  <a:pt x="232" y="1760"/>
                  <a:pt x="336" y="1560"/>
                  <a:pt x="416" y="1560"/>
                </a:cubicBezTo>
                <a:cubicBezTo>
                  <a:pt x="496" y="1560"/>
                  <a:pt x="584" y="1760"/>
                  <a:pt x="656" y="1752"/>
                </a:cubicBezTo>
                <a:cubicBezTo>
                  <a:pt x="728" y="1744"/>
                  <a:pt x="864" y="1584"/>
                  <a:pt x="848" y="1512"/>
                </a:cubicBezTo>
                <a:cubicBezTo>
                  <a:pt x="832" y="1440"/>
                  <a:pt x="608" y="1488"/>
                  <a:pt x="560" y="1320"/>
                </a:cubicBezTo>
                <a:cubicBezTo>
                  <a:pt x="512" y="1152"/>
                  <a:pt x="528" y="648"/>
                  <a:pt x="560" y="504"/>
                </a:cubicBezTo>
                <a:cubicBezTo>
                  <a:pt x="592" y="360"/>
                  <a:pt x="728" y="352"/>
                  <a:pt x="752" y="456"/>
                </a:cubicBezTo>
                <a:cubicBezTo>
                  <a:pt x="776" y="560"/>
                  <a:pt x="696" y="992"/>
                  <a:pt x="704" y="1128"/>
                </a:cubicBezTo>
                <a:cubicBezTo>
                  <a:pt x="712" y="1264"/>
                  <a:pt x="760" y="1264"/>
                  <a:pt x="800" y="1272"/>
                </a:cubicBezTo>
                <a:cubicBezTo>
                  <a:pt x="840" y="1280"/>
                  <a:pt x="920" y="1312"/>
                  <a:pt x="944" y="1176"/>
                </a:cubicBezTo>
                <a:cubicBezTo>
                  <a:pt x="968" y="1040"/>
                  <a:pt x="920" y="592"/>
                  <a:pt x="944" y="456"/>
                </a:cubicBezTo>
                <a:cubicBezTo>
                  <a:pt x="968" y="320"/>
                  <a:pt x="1056" y="280"/>
                  <a:pt x="1088" y="360"/>
                </a:cubicBezTo>
                <a:cubicBezTo>
                  <a:pt x="1120" y="440"/>
                  <a:pt x="1136" y="784"/>
                  <a:pt x="1136" y="936"/>
                </a:cubicBezTo>
                <a:cubicBezTo>
                  <a:pt x="1136" y="1088"/>
                  <a:pt x="1056" y="1224"/>
                  <a:pt x="1088" y="1272"/>
                </a:cubicBezTo>
                <a:cubicBezTo>
                  <a:pt x="1120" y="1320"/>
                  <a:pt x="1288" y="1352"/>
                  <a:pt x="1328" y="1224"/>
                </a:cubicBezTo>
                <a:cubicBezTo>
                  <a:pt x="1368" y="1096"/>
                  <a:pt x="1320" y="648"/>
                  <a:pt x="1328" y="504"/>
                </a:cubicBezTo>
                <a:cubicBezTo>
                  <a:pt x="1336" y="360"/>
                  <a:pt x="1328" y="384"/>
                  <a:pt x="1376" y="360"/>
                </a:cubicBezTo>
                <a:cubicBezTo>
                  <a:pt x="1424" y="336"/>
                  <a:pt x="1568" y="352"/>
                  <a:pt x="1616" y="360"/>
                </a:cubicBezTo>
              </a:path>
            </a:pathLst>
          </a:custGeom>
          <a:noFill/>
          <a:ln w="28575" cmpd="sng">
            <a:solidFill>
              <a:srgbClr val="000000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308" name="フリーフォーム 307"/>
          <p:cNvSpPr/>
          <p:nvPr/>
        </p:nvSpPr>
        <p:spPr>
          <a:xfrm>
            <a:off x="3203215" y="6811699"/>
            <a:ext cx="612106" cy="516414"/>
          </a:xfrm>
          <a:custGeom>
            <a:avLst/>
            <a:gdLst>
              <a:gd name="connsiteX0" fmla="*/ 9098 w 1177498"/>
              <a:gd name="connsiteY0" fmla="*/ 0 h 897466"/>
              <a:gd name="connsiteX1" fmla="*/ 26032 w 1177498"/>
              <a:gd name="connsiteY1" fmla="*/ 448733 h 897466"/>
              <a:gd name="connsiteX2" fmla="*/ 229232 w 1177498"/>
              <a:gd name="connsiteY2" fmla="*/ 592666 h 897466"/>
              <a:gd name="connsiteX3" fmla="*/ 804965 w 1177498"/>
              <a:gd name="connsiteY3" fmla="*/ 694266 h 897466"/>
              <a:gd name="connsiteX4" fmla="*/ 1177498 w 1177498"/>
              <a:gd name="connsiteY4" fmla="*/ 897466 h 8974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177498" h="897466">
                <a:moveTo>
                  <a:pt x="9098" y="0"/>
                </a:moveTo>
                <a:cubicBezTo>
                  <a:pt x="-780" y="174977"/>
                  <a:pt x="-10657" y="349955"/>
                  <a:pt x="26032" y="448733"/>
                </a:cubicBezTo>
                <a:cubicBezTo>
                  <a:pt x="62721" y="547511"/>
                  <a:pt x="99410" y="551744"/>
                  <a:pt x="229232" y="592666"/>
                </a:cubicBezTo>
                <a:cubicBezTo>
                  <a:pt x="359054" y="633588"/>
                  <a:pt x="646921" y="643466"/>
                  <a:pt x="804965" y="694266"/>
                </a:cubicBezTo>
                <a:cubicBezTo>
                  <a:pt x="963009" y="745066"/>
                  <a:pt x="1177498" y="897466"/>
                  <a:pt x="1177498" y="897466"/>
                </a:cubicBezTo>
              </a:path>
            </a:pathLst>
          </a:custGeom>
          <a:ln w="12700" cmpd="sng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9" name="フリーフォーム 308"/>
          <p:cNvSpPr/>
          <p:nvPr/>
        </p:nvSpPr>
        <p:spPr>
          <a:xfrm>
            <a:off x="2935369" y="7189710"/>
            <a:ext cx="173872" cy="1139002"/>
          </a:xfrm>
          <a:custGeom>
            <a:avLst/>
            <a:gdLst>
              <a:gd name="connsiteX0" fmla="*/ 0 w 438338"/>
              <a:gd name="connsiteY0" fmla="*/ 1888066 h 1888066"/>
              <a:gd name="connsiteX1" fmla="*/ 414866 w 438338"/>
              <a:gd name="connsiteY1" fmla="*/ 1278466 h 1888066"/>
              <a:gd name="connsiteX2" fmla="*/ 389466 w 438338"/>
              <a:gd name="connsiteY2" fmla="*/ 0 h 18880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438338" h="1888066">
                <a:moveTo>
                  <a:pt x="0" y="1888066"/>
                </a:moveTo>
                <a:cubicBezTo>
                  <a:pt x="174977" y="1740605"/>
                  <a:pt x="349955" y="1593144"/>
                  <a:pt x="414866" y="1278466"/>
                </a:cubicBezTo>
                <a:cubicBezTo>
                  <a:pt x="479777" y="963788"/>
                  <a:pt x="389466" y="0"/>
                  <a:pt x="389466" y="0"/>
                </a:cubicBezTo>
              </a:path>
            </a:pathLst>
          </a:custGeom>
          <a:ln w="12700">
            <a:solidFill>
              <a:schemeClr val="tx1"/>
            </a:solidFill>
            <a:prstDash val="solid"/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0" name="円弧 309"/>
          <p:cNvSpPr/>
          <p:nvPr/>
        </p:nvSpPr>
        <p:spPr>
          <a:xfrm>
            <a:off x="3724073" y="6811700"/>
            <a:ext cx="965376" cy="1693186"/>
          </a:xfrm>
          <a:prstGeom prst="arc">
            <a:avLst>
              <a:gd name="adj1" fmla="val 16720059"/>
              <a:gd name="adj2" fmla="val 4307091"/>
            </a:avLst>
          </a:prstGeom>
          <a:ln w="12700">
            <a:solidFill>
              <a:srgbClr val="000000"/>
            </a:solidFill>
            <a:prstDash val="solid"/>
            <a:headEnd type="arrow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1" name="フリーフォーム 310"/>
          <p:cNvSpPr/>
          <p:nvPr/>
        </p:nvSpPr>
        <p:spPr>
          <a:xfrm>
            <a:off x="1728161" y="7432816"/>
            <a:ext cx="111213" cy="129318"/>
          </a:xfrm>
          <a:custGeom>
            <a:avLst/>
            <a:gdLst>
              <a:gd name="connsiteX0" fmla="*/ 136525 w 136525"/>
              <a:gd name="connsiteY0" fmla="*/ 0 h 158750"/>
              <a:gd name="connsiteX1" fmla="*/ 38100 w 136525"/>
              <a:gd name="connsiteY1" fmla="*/ 34925 h 158750"/>
              <a:gd name="connsiteX2" fmla="*/ 0 w 136525"/>
              <a:gd name="connsiteY2" fmla="*/ 76200 h 158750"/>
              <a:gd name="connsiteX3" fmla="*/ 19050 w 136525"/>
              <a:gd name="connsiteY3" fmla="*/ 111125 h 158750"/>
              <a:gd name="connsiteX4" fmla="*/ 66675 w 136525"/>
              <a:gd name="connsiteY4" fmla="*/ 139700 h 158750"/>
              <a:gd name="connsiteX5" fmla="*/ 123825 w 136525"/>
              <a:gd name="connsiteY5" fmla="*/ 158750 h 158750"/>
              <a:gd name="connsiteX6" fmla="*/ 123825 w 136525"/>
              <a:gd name="connsiteY6" fmla="*/ 158750 h 158750"/>
              <a:gd name="connsiteX7" fmla="*/ 117475 w 136525"/>
              <a:gd name="connsiteY7" fmla="*/ 88900 h 158750"/>
              <a:gd name="connsiteX8" fmla="*/ 136525 w 136525"/>
              <a:gd name="connsiteY8" fmla="*/ 0 h 1587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136525" h="158750">
                <a:moveTo>
                  <a:pt x="136525" y="0"/>
                </a:moveTo>
                <a:lnTo>
                  <a:pt x="38100" y="34925"/>
                </a:lnTo>
                <a:lnTo>
                  <a:pt x="0" y="76200"/>
                </a:lnTo>
                <a:lnTo>
                  <a:pt x="19050" y="111125"/>
                </a:lnTo>
                <a:lnTo>
                  <a:pt x="66675" y="139700"/>
                </a:lnTo>
                <a:lnTo>
                  <a:pt x="123825" y="158750"/>
                </a:lnTo>
                <a:lnTo>
                  <a:pt x="123825" y="158750"/>
                </a:lnTo>
                <a:lnTo>
                  <a:pt x="117475" y="88900"/>
                </a:lnTo>
                <a:lnTo>
                  <a:pt x="136525" y="0"/>
                </a:lnTo>
                <a:close/>
              </a:path>
            </a:pathLst>
          </a:custGeom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2" name="フリーフォーム 311"/>
          <p:cNvSpPr/>
          <p:nvPr/>
        </p:nvSpPr>
        <p:spPr>
          <a:xfrm>
            <a:off x="1864027" y="7400656"/>
            <a:ext cx="115854" cy="74823"/>
          </a:xfrm>
          <a:custGeom>
            <a:avLst/>
            <a:gdLst>
              <a:gd name="connsiteX0" fmla="*/ 6350 w 152400"/>
              <a:gd name="connsiteY0" fmla="*/ 12700 h 98425"/>
              <a:gd name="connsiteX1" fmla="*/ 104775 w 152400"/>
              <a:gd name="connsiteY1" fmla="*/ 0 h 98425"/>
              <a:gd name="connsiteX2" fmla="*/ 152400 w 152400"/>
              <a:gd name="connsiteY2" fmla="*/ 25400 h 98425"/>
              <a:gd name="connsiteX3" fmla="*/ 136525 w 152400"/>
              <a:gd name="connsiteY3" fmla="*/ 50800 h 98425"/>
              <a:gd name="connsiteX4" fmla="*/ 111125 w 152400"/>
              <a:gd name="connsiteY4" fmla="*/ 98425 h 98425"/>
              <a:gd name="connsiteX5" fmla="*/ 50800 w 152400"/>
              <a:gd name="connsiteY5" fmla="*/ 92075 h 98425"/>
              <a:gd name="connsiteX6" fmla="*/ 0 w 152400"/>
              <a:gd name="connsiteY6" fmla="*/ 95250 h 98425"/>
              <a:gd name="connsiteX7" fmla="*/ 6350 w 152400"/>
              <a:gd name="connsiteY7" fmla="*/ 12700 h 984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152400" h="98425">
                <a:moveTo>
                  <a:pt x="6350" y="12700"/>
                </a:moveTo>
                <a:lnTo>
                  <a:pt x="104775" y="0"/>
                </a:lnTo>
                <a:lnTo>
                  <a:pt x="152400" y="25400"/>
                </a:lnTo>
                <a:lnTo>
                  <a:pt x="136525" y="50800"/>
                </a:lnTo>
                <a:lnTo>
                  <a:pt x="111125" y="98425"/>
                </a:lnTo>
                <a:lnTo>
                  <a:pt x="50800" y="92075"/>
                </a:lnTo>
                <a:lnTo>
                  <a:pt x="0" y="95250"/>
                </a:lnTo>
                <a:lnTo>
                  <a:pt x="6350" y="12700"/>
                </a:lnTo>
                <a:close/>
              </a:path>
            </a:pathLst>
          </a:custGeom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3" name="フリーフォーム 312"/>
          <p:cNvSpPr/>
          <p:nvPr/>
        </p:nvSpPr>
        <p:spPr>
          <a:xfrm>
            <a:off x="1864026" y="7523633"/>
            <a:ext cx="199475" cy="77086"/>
          </a:xfrm>
          <a:custGeom>
            <a:avLst/>
            <a:gdLst>
              <a:gd name="connsiteX0" fmla="*/ 17318 w 248895"/>
              <a:gd name="connsiteY0" fmla="*/ 7026 h 96183"/>
              <a:gd name="connsiteX1" fmla="*/ 14143 w 248895"/>
              <a:gd name="connsiteY1" fmla="*/ 70526 h 96183"/>
              <a:gd name="connsiteX2" fmla="*/ 163368 w 248895"/>
              <a:gd name="connsiteY2" fmla="*/ 95926 h 96183"/>
              <a:gd name="connsiteX3" fmla="*/ 239568 w 248895"/>
              <a:gd name="connsiteY3" fmla="*/ 80051 h 96183"/>
              <a:gd name="connsiteX4" fmla="*/ 242743 w 248895"/>
              <a:gd name="connsiteY4" fmla="*/ 26076 h 96183"/>
              <a:gd name="connsiteX5" fmla="*/ 195118 w 248895"/>
              <a:gd name="connsiteY5" fmla="*/ 676 h 96183"/>
              <a:gd name="connsiteX6" fmla="*/ 153843 w 248895"/>
              <a:gd name="connsiteY6" fmla="*/ 7026 h 96183"/>
              <a:gd name="connsiteX7" fmla="*/ 112568 w 248895"/>
              <a:gd name="connsiteY7" fmla="*/ 3851 h 96183"/>
              <a:gd name="connsiteX8" fmla="*/ 17318 w 248895"/>
              <a:gd name="connsiteY8" fmla="*/ 7026 h 9618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248895" h="96183">
                <a:moveTo>
                  <a:pt x="17318" y="7026"/>
                </a:moveTo>
                <a:cubicBezTo>
                  <a:pt x="914" y="18138"/>
                  <a:pt x="-10199" y="55709"/>
                  <a:pt x="14143" y="70526"/>
                </a:cubicBezTo>
                <a:cubicBezTo>
                  <a:pt x="38485" y="85343"/>
                  <a:pt x="125797" y="94339"/>
                  <a:pt x="163368" y="95926"/>
                </a:cubicBezTo>
                <a:cubicBezTo>
                  <a:pt x="200939" y="97513"/>
                  <a:pt x="226339" y="91693"/>
                  <a:pt x="239568" y="80051"/>
                </a:cubicBezTo>
                <a:cubicBezTo>
                  <a:pt x="252797" y="68409"/>
                  <a:pt x="250151" y="39305"/>
                  <a:pt x="242743" y="26076"/>
                </a:cubicBezTo>
                <a:cubicBezTo>
                  <a:pt x="235335" y="12847"/>
                  <a:pt x="209935" y="3851"/>
                  <a:pt x="195118" y="676"/>
                </a:cubicBezTo>
                <a:cubicBezTo>
                  <a:pt x="180301" y="-2499"/>
                  <a:pt x="167601" y="6497"/>
                  <a:pt x="153843" y="7026"/>
                </a:cubicBezTo>
                <a:cubicBezTo>
                  <a:pt x="140085" y="7555"/>
                  <a:pt x="132676" y="4380"/>
                  <a:pt x="112568" y="3851"/>
                </a:cubicBezTo>
                <a:cubicBezTo>
                  <a:pt x="92460" y="3322"/>
                  <a:pt x="33722" y="-4086"/>
                  <a:pt x="17318" y="7026"/>
                </a:cubicBezTo>
                <a:close/>
              </a:path>
            </a:pathLst>
          </a:custGeom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4" name="フリーフォーム 313"/>
          <p:cNvSpPr/>
          <p:nvPr/>
        </p:nvSpPr>
        <p:spPr>
          <a:xfrm>
            <a:off x="1991692" y="7417091"/>
            <a:ext cx="201023" cy="145043"/>
          </a:xfrm>
          <a:custGeom>
            <a:avLst/>
            <a:gdLst>
              <a:gd name="connsiteX0" fmla="*/ 25400 w 250825"/>
              <a:gd name="connsiteY0" fmla="*/ 0 h 180975"/>
              <a:gd name="connsiteX1" fmla="*/ 0 w 250825"/>
              <a:gd name="connsiteY1" fmla="*/ 66675 h 180975"/>
              <a:gd name="connsiteX2" fmla="*/ 0 w 250825"/>
              <a:gd name="connsiteY2" fmla="*/ 98425 h 180975"/>
              <a:gd name="connsiteX3" fmla="*/ 50800 w 250825"/>
              <a:gd name="connsiteY3" fmla="*/ 88900 h 180975"/>
              <a:gd name="connsiteX4" fmla="*/ 82550 w 250825"/>
              <a:gd name="connsiteY4" fmla="*/ 104775 h 180975"/>
              <a:gd name="connsiteX5" fmla="*/ 107950 w 250825"/>
              <a:gd name="connsiteY5" fmla="*/ 123825 h 180975"/>
              <a:gd name="connsiteX6" fmla="*/ 111125 w 250825"/>
              <a:gd name="connsiteY6" fmla="*/ 149225 h 180975"/>
              <a:gd name="connsiteX7" fmla="*/ 104775 w 250825"/>
              <a:gd name="connsiteY7" fmla="*/ 180975 h 180975"/>
              <a:gd name="connsiteX8" fmla="*/ 171450 w 250825"/>
              <a:gd name="connsiteY8" fmla="*/ 165100 h 180975"/>
              <a:gd name="connsiteX9" fmla="*/ 193675 w 250825"/>
              <a:gd name="connsiteY9" fmla="*/ 142875 h 180975"/>
              <a:gd name="connsiteX10" fmla="*/ 241300 w 250825"/>
              <a:gd name="connsiteY10" fmla="*/ 107950 h 180975"/>
              <a:gd name="connsiteX11" fmla="*/ 250825 w 250825"/>
              <a:gd name="connsiteY11" fmla="*/ 76200 h 180975"/>
              <a:gd name="connsiteX12" fmla="*/ 231775 w 250825"/>
              <a:gd name="connsiteY12" fmla="*/ 50800 h 180975"/>
              <a:gd name="connsiteX13" fmla="*/ 158750 w 250825"/>
              <a:gd name="connsiteY13" fmla="*/ 28575 h 180975"/>
              <a:gd name="connsiteX14" fmla="*/ 111125 w 250825"/>
              <a:gd name="connsiteY14" fmla="*/ 6350 h 180975"/>
              <a:gd name="connsiteX15" fmla="*/ 85725 w 250825"/>
              <a:gd name="connsiteY15" fmla="*/ 6350 h 180975"/>
              <a:gd name="connsiteX16" fmla="*/ 25400 w 250825"/>
              <a:gd name="connsiteY16" fmla="*/ 0 h 1809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250825" h="180975">
                <a:moveTo>
                  <a:pt x="25400" y="0"/>
                </a:moveTo>
                <a:lnTo>
                  <a:pt x="0" y="66675"/>
                </a:lnTo>
                <a:lnTo>
                  <a:pt x="0" y="98425"/>
                </a:lnTo>
                <a:lnTo>
                  <a:pt x="50800" y="88900"/>
                </a:lnTo>
                <a:lnTo>
                  <a:pt x="82550" y="104775"/>
                </a:lnTo>
                <a:lnTo>
                  <a:pt x="107950" y="123825"/>
                </a:lnTo>
                <a:lnTo>
                  <a:pt x="111125" y="149225"/>
                </a:lnTo>
                <a:lnTo>
                  <a:pt x="104775" y="180975"/>
                </a:lnTo>
                <a:lnTo>
                  <a:pt x="171450" y="165100"/>
                </a:lnTo>
                <a:lnTo>
                  <a:pt x="193675" y="142875"/>
                </a:lnTo>
                <a:lnTo>
                  <a:pt x="241300" y="107950"/>
                </a:lnTo>
                <a:lnTo>
                  <a:pt x="250825" y="76200"/>
                </a:lnTo>
                <a:lnTo>
                  <a:pt x="231775" y="50800"/>
                </a:lnTo>
                <a:lnTo>
                  <a:pt x="158750" y="28575"/>
                </a:lnTo>
                <a:lnTo>
                  <a:pt x="111125" y="6350"/>
                </a:lnTo>
                <a:lnTo>
                  <a:pt x="85725" y="6350"/>
                </a:lnTo>
                <a:lnTo>
                  <a:pt x="25400" y="0"/>
                </a:lnTo>
                <a:close/>
              </a:path>
            </a:pathLst>
          </a:custGeom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315" name="直線コネクタ 314"/>
          <p:cNvCxnSpPr/>
          <p:nvPr/>
        </p:nvCxnSpPr>
        <p:spPr>
          <a:xfrm>
            <a:off x="2403257" y="8176511"/>
            <a:ext cx="118986" cy="2054"/>
          </a:xfrm>
          <a:prstGeom prst="line">
            <a:avLst/>
          </a:prstGeom>
          <a:ln w="12700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6" name="直線コネクタ 315"/>
          <p:cNvCxnSpPr/>
          <p:nvPr/>
        </p:nvCxnSpPr>
        <p:spPr>
          <a:xfrm flipV="1">
            <a:off x="2522244" y="8131315"/>
            <a:ext cx="0" cy="98611"/>
          </a:xfrm>
          <a:prstGeom prst="line">
            <a:avLst/>
          </a:prstGeom>
          <a:ln w="12700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17" name="テキスト ボックス 316"/>
          <p:cNvSpPr txBox="1"/>
          <p:nvPr/>
        </p:nvSpPr>
        <p:spPr>
          <a:xfrm>
            <a:off x="3078061" y="8041697"/>
            <a:ext cx="6479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/>
                <a:cs typeface="Arial"/>
              </a:rPr>
              <a:t>Nucleus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318" name="テキスト ボックス 317"/>
          <p:cNvSpPr txBox="1"/>
          <p:nvPr/>
        </p:nvSpPr>
        <p:spPr>
          <a:xfrm>
            <a:off x="1783551" y="7025590"/>
            <a:ext cx="7904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/>
                <a:cs typeface="Arial"/>
              </a:rPr>
              <a:t>Cytoplasm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319" name="テキスト ボックス 318"/>
          <p:cNvSpPr txBox="1"/>
          <p:nvPr/>
        </p:nvSpPr>
        <p:spPr>
          <a:xfrm>
            <a:off x="1738943" y="8533954"/>
            <a:ext cx="4554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/>
                <a:cs typeface="Arial"/>
              </a:rPr>
              <a:t>DNA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320" name="正方形/長方形 319"/>
          <p:cNvSpPr/>
          <p:nvPr/>
        </p:nvSpPr>
        <p:spPr>
          <a:xfrm>
            <a:off x="3038294" y="8557605"/>
            <a:ext cx="415620" cy="187556"/>
          </a:xfrm>
          <a:prstGeom prst="rect">
            <a:avLst/>
          </a:prstGeom>
          <a:solidFill>
            <a:srgbClr val="FFFFFF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1" name="Line 431"/>
          <p:cNvSpPr>
            <a:spLocks noChangeShapeType="1"/>
          </p:cNvSpPr>
          <p:nvPr/>
        </p:nvSpPr>
        <p:spPr bwMode="auto">
          <a:xfrm flipH="1" flipV="1">
            <a:off x="3762774" y="8489750"/>
            <a:ext cx="1028" cy="146619"/>
          </a:xfrm>
          <a:prstGeom prst="line">
            <a:avLst/>
          </a:prstGeom>
          <a:noFill/>
          <a:ln w="12700" cmpd="sng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>
              <a:solidFill>
                <a:srgbClr val="000000"/>
              </a:solidFill>
            </a:endParaRPr>
          </a:p>
        </p:txBody>
      </p:sp>
      <p:sp>
        <p:nvSpPr>
          <p:cNvPr id="322" name="Line 294"/>
          <p:cNvSpPr>
            <a:spLocks noChangeShapeType="1"/>
          </p:cNvSpPr>
          <p:nvPr/>
        </p:nvSpPr>
        <p:spPr bwMode="auto">
          <a:xfrm>
            <a:off x="2559392" y="8533352"/>
            <a:ext cx="274263" cy="0"/>
          </a:xfrm>
          <a:prstGeom prst="line">
            <a:avLst/>
          </a:prstGeom>
          <a:noFill/>
          <a:ln w="12700" cmpd="sng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323" name="Line 431"/>
          <p:cNvSpPr>
            <a:spLocks noChangeShapeType="1"/>
          </p:cNvSpPr>
          <p:nvPr/>
        </p:nvSpPr>
        <p:spPr bwMode="auto">
          <a:xfrm flipH="1" flipV="1">
            <a:off x="2558364" y="8529375"/>
            <a:ext cx="0" cy="64715"/>
          </a:xfrm>
          <a:prstGeom prst="line">
            <a:avLst/>
          </a:prstGeom>
          <a:noFill/>
          <a:ln w="12700" cmpd="sng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>
              <a:solidFill>
                <a:srgbClr val="000000"/>
              </a:solidFill>
            </a:endParaRPr>
          </a:p>
        </p:txBody>
      </p:sp>
      <p:sp>
        <p:nvSpPr>
          <p:cNvPr id="324" name="Line 282"/>
          <p:cNvSpPr>
            <a:spLocks noChangeShapeType="1"/>
          </p:cNvSpPr>
          <p:nvPr/>
        </p:nvSpPr>
        <p:spPr bwMode="auto">
          <a:xfrm>
            <a:off x="4013555" y="7457469"/>
            <a:ext cx="99524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>
              <a:solidFill>
                <a:srgbClr val="000000"/>
              </a:solidFill>
            </a:endParaRPr>
          </a:p>
        </p:txBody>
      </p:sp>
      <p:sp>
        <p:nvSpPr>
          <p:cNvPr id="325" name="Line 282"/>
          <p:cNvSpPr>
            <a:spLocks noChangeShapeType="1"/>
          </p:cNvSpPr>
          <p:nvPr/>
        </p:nvSpPr>
        <p:spPr bwMode="auto">
          <a:xfrm>
            <a:off x="3815321" y="7463414"/>
            <a:ext cx="99524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>
              <a:solidFill>
                <a:srgbClr val="000000"/>
              </a:solidFill>
            </a:endParaRPr>
          </a:p>
        </p:txBody>
      </p:sp>
      <p:sp>
        <p:nvSpPr>
          <p:cNvPr id="326" name="テキスト ボックス 325"/>
          <p:cNvSpPr txBox="1"/>
          <p:nvPr/>
        </p:nvSpPr>
        <p:spPr>
          <a:xfrm>
            <a:off x="4762911" y="8369448"/>
            <a:ext cx="1695935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/>
                <a:cs typeface="Arial"/>
              </a:rPr>
              <a:t>Suppression of E-cadherin</a:t>
            </a:r>
          </a:p>
          <a:p>
            <a:r>
              <a:rPr lang="en-US" altLang="ja-JP" sz="1000" dirty="0">
                <a:latin typeface="Arial"/>
                <a:cs typeface="Arial"/>
              </a:rPr>
              <a:t>      (M zone)</a:t>
            </a:r>
            <a:r>
              <a:rPr lang="ja-JP" altLang="ja-JP" sz="1000" dirty="0">
                <a:latin typeface="Arial"/>
                <a:cs typeface="Arial"/>
              </a:rPr>
              <a:t> </a:t>
            </a:r>
            <a:endParaRPr lang="en-US" altLang="ja-JP" sz="1000" dirty="0">
              <a:latin typeface="Arial"/>
              <a:cs typeface="Arial"/>
            </a:endParaRPr>
          </a:p>
          <a:p>
            <a:r>
              <a:rPr lang="en-US" altLang="ja-JP" sz="1000" dirty="0">
                <a:latin typeface="Arial"/>
                <a:cs typeface="Arial"/>
              </a:rPr>
              <a:t> invasion and metastasis</a:t>
            </a:r>
          </a:p>
          <a:p>
            <a:r>
              <a:rPr lang="en-US" altLang="ja-JP" sz="1000" dirty="0">
                <a:latin typeface="Arial"/>
                <a:cs typeface="Arial"/>
              </a:rPr>
              <a:t>        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327" name="テキスト ボックス 326"/>
          <p:cNvSpPr txBox="1"/>
          <p:nvPr/>
        </p:nvSpPr>
        <p:spPr>
          <a:xfrm>
            <a:off x="4453172" y="6484630"/>
            <a:ext cx="161741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/>
                <a:cs typeface="Arial"/>
              </a:rPr>
              <a:t>Expression of E-cadherin</a:t>
            </a:r>
          </a:p>
          <a:p>
            <a:r>
              <a:rPr lang="en-US" altLang="ja-JP" sz="1000" dirty="0">
                <a:latin typeface="Arial"/>
                <a:cs typeface="Arial"/>
              </a:rPr>
              <a:t>     (</a:t>
            </a:r>
            <a:r>
              <a:rPr kumimoji="1" lang="en-US" altLang="ja-JP" sz="1000" dirty="0">
                <a:latin typeface="Arial"/>
                <a:cs typeface="Arial"/>
              </a:rPr>
              <a:t>E</a:t>
            </a:r>
            <a:r>
              <a:rPr lang="en-US" altLang="ja-JP" sz="1000" dirty="0">
                <a:latin typeface="Arial"/>
                <a:cs typeface="Arial"/>
              </a:rPr>
              <a:t> zone)</a:t>
            </a:r>
            <a:r>
              <a:rPr lang="ja-JP" altLang="ja-JP" sz="1000" dirty="0">
                <a:latin typeface="Arial"/>
                <a:cs typeface="Arial"/>
              </a:rPr>
              <a:t> 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328" name="テキスト ボックス 327"/>
          <p:cNvSpPr txBox="1"/>
          <p:nvPr/>
        </p:nvSpPr>
        <p:spPr>
          <a:xfrm>
            <a:off x="913582" y="7347345"/>
            <a:ext cx="7975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/>
                <a:cs typeface="Arial"/>
              </a:rPr>
              <a:t>Fragments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cxnSp>
        <p:nvCxnSpPr>
          <p:cNvPr id="329" name="直線コネクタ 328"/>
          <p:cNvCxnSpPr/>
          <p:nvPr/>
        </p:nvCxnSpPr>
        <p:spPr>
          <a:xfrm>
            <a:off x="1960831" y="7640215"/>
            <a:ext cx="0" cy="290935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30" name="直線コネクタ 329"/>
          <p:cNvCxnSpPr/>
          <p:nvPr/>
        </p:nvCxnSpPr>
        <p:spPr>
          <a:xfrm>
            <a:off x="1908712" y="7934638"/>
            <a:ext cx="102919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31" name="テキスト ボックス 330"/>
          <p:cNvSpPr txBox="1"/>
          <p:nvPr/>
        </p:nvSpPr>
        <p:spPr>
          <a:xfrm>
            <a:off x="4622421" y="8353693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/>
                <a:cs typeface="Arial"/>
              </a:rPr>
              <a:t>↓</a:t>
            </a:r>
            <a:r>
              <a:rPr kumimoji="1" lang="ja-JP" altLang="en-US" sz="1000" dirty="0">
                <a:latin typeface="Arial"/>
                <a:cs typeface="Arial"/>
              </a:rPr>
              <a:t>　</a:t>
            </a:r>
            <a:r>
              <a:rPr lang="en-US" altLang="ja-JP" sz="1000" dirty="0">
                <a:latin typeface="Arial"/>
                <a:cs typeface="Arial"/>
              </a:rPr>
              <a:t> 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332" name="Freeform 429"/>
          <p:cNvSpPr>
            <a:spLocks/>
          </p:cNvSpPr>
          <p:nvPr/>
        </p:nvSpPr>
        <p:spPr bwMode="auto">
          <a:xfrm>
            <a:off x="2177777" y="8605256"/>
            <a:ext cx="1471167" cy="113347"/>
          </a:xfrm>
          <a:custGeom>
            <a:avLst/>
            <a:gdLst>
              <a:gd name="T0" fmla="*/ 0 w 2054"/>
              <a:gd name="T1" fmla="*/ 102 h 105"/>
              <a:gd name="T2" fmla="*/ 101 w 2054"/>
              <a:gd name="T3" fmla="*/ 6 h 105"/>
              <a:gd name="T4" fmla="*/ 205 w 2054"/>
              <a:gd name="T5" fmla="*/ 104 h 105"/>
              <a:gd name="T6" fmla="*/ 309 w 2054"/>
              <a:gd name="T7" fmla="*/ 6 h 105"/>
              <a:gd name="T8" fmla="*/ 414 w 2054"/>
              <a:gd name="T9" fmla="*/ 104 h 105"/>
              <a:gd name="T10" fmla="*/ 524 w 2054"/>
              <a:gd name="T11" fmla="*/ 6 h 105"/>
              <a:gd name="T12" fmla="*/ 622 w 2054"/>
              <a:gd name="T13" fmla="*/ 104 h 105"/>
              <a:gd name="T14" fmla="*/ 727 w 2054"/>
              <a:gd name="T15" fmla="*/ 0 h 105"/>
              <a:gd name="T16" fmla="*/ 831 w 2054"/>
              <a:gd name="T17" fmla="*/ 104 h 105"/>
              <a:gd name="T18" fmla="*/ 930 w 2054"/>
              <a:gd name="T19" fmla="*/ 6 h 105"/>
              <a:gd name="T20" fmla="*/ 1034 w 2054"/>
              <a:gd name="T21" fmla="*/ 104 h 105"/>
              <a:gd name="T22" fmla="*/ 1138 w 2054"/>
              <a:gd name="T23" fmla="*/ 6 h 105"/>
              <a:gd name="T24" fmla="*/ 1243 w 2054"/>
              <a:gd name="T25" fmla="*/ 104 h 105"/>
              <a:gd name="T26" fmla="*/ 1347 w 2054"/>
              <a:gd name="T27" fmla="*/ 6 h 105"/>
              <a:gd name="T28" fmla="*/ 1451 w 2054"/>
              <a:gd name="T29" fmla="*/ 104 h 105"/>
              <a:gd name="T30" fmla="*/ 1556 w 2054"/>
              <a:gd name="T31" fmla="*/ 6 h 105"/>
              <a:gd name="T32" fmla="*/ 1654 w 2054"/>
              <a:gd name="T33" fmla="*/ 104 h 105"/>
              <a:gd name="T34" fmla="*/ 1759 w 2054"/>
              <a:gd name="T35" fmla="*/ 6 h 105"/>
              <a:gd name="T36" fmla="*/ 1863 w 2054"/>
              <a:gd name="T37" fmla="*/ 104 h 105"/>
              <a:gd name="T38" fmla="*/ 1967 w 2054"/>
              <a:gd name="T39" fmla="*/ 6 h 105"/>
              <a:gd name="T40" fmla="*/ 2054 w 2054"/>
              <a:gd name="T41" fmla="*/ 104 h 10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</a:cxnLst>
            <a:rect l="0" t="0" r="r" b="b"/>
            <a:pathLst>
              <a:path w="2054" h="105">
                <a:moveTo>
                  <a:pt x="0" y="102"/>
                </a:moveTo>
                <a:cubicBezTo>
                  <a:pt x="33" y="54"/>
                  <a:pt x="67" y="6"/>
                  <a:pt x="101" y="6"/>
                </a:cubicBezTo>
                <a:cubicBezTo>
                  <a:pt x="135" y="6"/>
                  <a:pt x="170" y="104"/>
                  <a:pt x="205" y="104"/>
                </a:cubicBezTo>
                <a:cubicBezTo>
                  <a:pt x="240" y="104"/>
                  <a:pt x="274" y="6"/>
                  <a:pt x="309" y="6"/>
                </a:cubicBezTo>
                <a:cubicBezTo>
                  <a:pt x="344" y="6"/>
                  <a:pt x="378" y="104"/>
                  <a:pt x="414" y="104"/>
                </a:cubicBezTo>
                <a:cubicBezTo>
                  <a:pt x="450" y="104"/>
                  <a:pt x="489" y="6"/>
                  <a:pt x="524" y="6"/>
                </a:cubicBezTo>
                <a:cubicBezTo>
                  <a:pt x="559" y="6"/>
                  <a:pt x="588" y="105"/>
                  <a:pt x="622" y="104"/>
                </a:cubicBezTo>
                <a:cubicBezTo>
                  <a:pt x="656" y="103"/>
                  <a:pt x="692" y="0"/>
                  <a:pt x="727" y="0"/>
                </a:cubicBezTo>
                <a:cubicBezTo>
                  <a:pt x="762" y="0"/>
                  <a:pt x="797" y="103"/>
                  <a:pt x="831" y="104"/>
                </a:cubicBezTo>
                <a:cubicBezTo>
                  <a:pt x="865" y="105"/>
                  <a:pt x="896" y="6"/>
                  <a:pt x="930" y="6"/>
                </a:cubicBezTo>
                <a:cubicBezTo>
                  <a:pt x="964" y="6"/>
                  <a:pt x="999" y="104"/>
                  <a:pt x="1034" y="104"/>
                </a:cubicBezTo>
                <a:cubicBezTo>
                  <a:pt x="1069" y="104"/>
                  <a:pt x="1103" y="6"/>
                  <a:pt x="1138" y="6"/>
                </a:cubicBezTo>
                <a:cubicBezTo>
                  <a:pt x="1173" y="6"/>
                  <a:pt x="1208" y="104"/>
                  <a:pt x="1243" y="104"/>
                </a:cubicBezTo>
                <a:cubicBezTo>
                  <a:pt x="1278" y="104"/>
                  <a:pt x="1312" y="6"/>
                  <a:pt x="1347" y="6"/>
                </a:cubicBezTo>
                <a:cubicBezTo>
                  <a:pt x="1382" y="6"/>
                  <a:pt x="1416" y="104"/>
                  <a:pt x="1451" y="104"/>
                </a:cubicBezTo>
                <a:cubicBezTo>
                  <a:pt x="1486" y="104"/>
                  <a:pt x="1522" y="6"/>
                  <a:pt x="1556" y="6"/>
                </a:cubicBezTo>
                <a:cubicBezTo>
                  <a:pt x="1590" y="6"/>
                  <a:pt x="1620" y="104"/>
                  <a:pt x="1654" y="104"/>
                </a:cubicBezTo>
                <a:cubicBezTo>
                  <a:pt x="1688" y="104"/>
                  <a:pt x="1724" y="6"/>
                  <a:pt x="1759" y="6"/>
                </a:cubicBezTo>
                <a:cubicBezTo>
                  <a:pt x="1794" y="6"/>
                  <a:pt x="1828" y="104"/>
                  <a:pt x="1863" y="104"/>
                </a:cubicBezTo>
                <a:cubicBezTo>
                  <a:pt x="1898" y="104"/>
                  <a:pt x="1935" y="6"/>
                  <a:pt x="1967" y="6"/>
                </a:cubicBezTo>
                <a:cubicBezTo>
                  <a:pt x="1999" y="6"/>
                  <a:pt x="2026" y="55"/>
                  <a:pt x="2054" y="104"/>
                </a:cubicBezTo>
              </a:path>
            </a:pathLst>
          </a:custGeom>
          <a:noFill/>
          <a:ln w="19050" cmpd="sng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bg1"/>
                </a:solidFill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>
              <a:solidFill>
                <a:srgbClr val="000000"/>
              </a:solidFill>
            </a:endParaRPr>
          </a:p>
        </p:txBody>
      </p:sp>
      <p:sp>
        <p:nvSpPr>
          <p:cNvPr id="333" name="正方形/長方形 332"/>
          <p:cNvSpPr/>
          <p:nvPr/>
        </p:nvSpPr>
        <p:spPr>
          <a:xfrm>
            <a:off x="3088951" y="8557605"/>
            <a:ext cx="601903" cy="187556"/>
          </a:xfrm>
          <a:prstGeom prst="rect">
            <a:avLst/>
          </a:prstGeom>
          <a:solidFill>
            <a:srgbClr val="FFFFFF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334" name="Group 427"/>
          <p:cNvGrpSpPr>
            <a:grpSpLocks/>
          </p:cNvGrpSpPr>
          <p:nvPr/>
        </p:nvGrpSpPr>
        <p:grpSpPr bwMode="auto">
          <a:xfrm>
            <a:off x="3285888" y="8601880"/>
            <a:ext cx="1522736" cy="114426"/>
            <a:chOff x="666" y="2049"/>
            <a:chExt cx="2126" cy="106"/>
          </a:xfrm>
        </p:grpSpPr>
        <p:sp>
          <p:nvSpPr>
            <p:cNvPr id="335" name="Freeform 428"/>
            <p:cNvSpPr>
              <a:spLocks/>
            </p:cNvSpPr>
            <p:nvPr/>
          </p:nvSpPr>
          <p:spPr bwMode="auto">
            <a:xfrm>
              <a:off x="666" y="2050"/>
              <a:ext cx="2054" cy="105"/>
            </a:xfrm>
            <a:custGeom>
              <a:avLst/>
              <a:gdLst>
                <a:gd name="T0" fmla="*/ 0 w 2054"/>
                <a:gd name="T1" fmla="*/ 102 h 105"/>
                <a:gd name="T2" fmla="*/ 101 w 2054"/>
                <a:gd name="T3" fmla="*/ 6 h 105"/>
                <a:gd name="T4" fmla="*/ 205 w 2054"/>
                <a:gd name="T5" fmla="*/ 104 h 105"/>
                <a:gd name="T6" fmla="*/ 309 w 2054"/>
                <a:gd name="T7" fmla="*/ 6 h 105"/>
                <a:gd name="T8" fmla="*/ 414 w 2054"/>
                <a:gd name="T9" fmla="*/ 104 h 105"/>
                <a:gd name="T10" fmla="*/ 524 w 2054"/>
                <a:gd name="T11" fmla="*/ 6 h 105"/>
                <a:gd name="T12" fmla="*/ 622 w 2054"/>
                <a:gd name="T13" fmla="*/ 104 h 105"/>
                <a:gd name="T14" fmla="*/ 727 w 2054"/>
                <a:gd name="T15" fmla="*/ 0 h 105"/>
                <a:gd name="T16" fmla="*/ 831 w 2054"/>
                <a:gd name="T17" fmla="*/ 104 h 105"/>
                <a:gd name="T18" fmla="*/ 930 w 2054"/>
                <a:gd name="T19" fmla="*/ 6 h 105"/>
                <a:gd name="T20" fmla="*/ 1034 w 2054"/>
                <a:gd name="T21" fmla="*/ 104 h 105"/>
                <a:gd name="T22" fmla="*/ 1138 w 2054"/>
                <a:gd name="T23" fmla="*/ 6 h 105"/>
                <a:gd name="T24" fmla="*/ 1243 w 2054"/>
                <a:gd name="T25" fmla="*/ 104 h 105"/>
                <a:gd name="T26" fmla="*/ 1347 w 2054"/>
                <a:gd name="T27" fmla="*/ 6 h 105"/>
                <a:gd name="T28" fmla="*/ 1451 w 2054"/>
                <a:gd name="T29" fmla="*/ 104 h 105"/>
                <a:gd name="T30" fmla="*/ 1556 w 2054"/>
                <a:gd name="T31" fmla="*/ 6 h 105"/>
                <a:gd name="T32" fmla="*/ 1654 w 2054"/>
                <a:gd name="T33" fmla="*/ 104 h 105"/>
                <a:gd name="T34" fmla="*/ 1759 w 2054"/>
                <a:gd name="T35" fmla="*/ 6 h 105"/>
                <a:gd name="T36" fmla="*/ 1863 w 2054"/>
                <a:gd name="T37" fmla="*/ 104 h 105"/>
                <a:gd name="T38" fmla="*/ 1967 w 2054"/>
                <a:gd name="T39" fmla="*/ 6 h 105"/>
                <a:gd name="T40" fmla="*/ 2054 w 2054"/>
                <a:gd name="T41" fmla="*/ 104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2054" h="105">
                  <a:moveTo>
                    <a:pt x="0" y="102"/>
                  </a:moveTo>
                  <a:cubicBezTo>
                    <a:pt x="33" y="54"/>
                    <a:pt x="67" y="6"/>
                    <a:pt x="101" y="6"/>
                  </a:cubicBezTo>
                  <a:cubicBezTo>
                    <a:pt x="135" y="6"/>
                    <a:pt x="170" y="104"/>
                    <a:pt x="205" y="104"/>
                  </a:cubicBezTo>
                  <a:cubicBezTo>
                    <a:pt x="240" y="104"/>
                    <a:pt x="274" y="6"/>
                    <a:pt x="309" y="6"/>
                  </a:cubicBezTo>
                  <a:cubicBezTo>
                    <a:pt x="344" y="6"/>
                    <a:pt x="378" y="104"/>
                    <a:pt x="414" y="104"/>
                  </a:cubicBezTo>
                  <a:cubicBezTo>
                    <a:pt x="450" y="104"/>
                    <a:pt x="489" y="6"/>
                    <a:pt x="524" y="6"/>
                  </a:cubicBezTo>
                  <a:cubicBezTo>
                    <a:pt x="559" y="6"/>
                    <a:pt x="588" y="105"/>
                    <a:pt x="622" y="104"/>
                  </a:cubicBezTo>
                  <a:cubicBezTo>
                    <a:pt x="656" y="103"/>
                    <a:pt x="692" y="0"/>
                    <a:pt x="727" y="0"/>
                  </a:cubicBezTo>
                  <a:cubicBezTo>
                    <a:pt x="762" y="0"/>
                    <a:pt x="797" y="103"/>
                    <a:pt x="831" y="104"/>
                  </a:cubicBezTo>
                  <a:cubicBezTo>
                    <a:pt x="865" y="105"/>
                    <a:pt x="896" y="6"/>
                    <a:pt x="930" y="6"/>
                  </a:cubicBezTo>
                  <a:cubicBezTo>
                    <a:pt x="964" y="6"/>
                    <a:pt x="999" y="104"/>
                    <a:pt x="1034" y="104"/>
                  </a:cubicBezTo>
                  <a:cubicBezTo>
                    <a:pt x="1069" y="104"/>
                    <a:pt x="1103" y="6"/>
                    <a:pt x="1138" y="6"/>
                  </a:cubicBezTo>
                  <a:cubicBezTo>
                    <a:pt x="1173" y="6"/>
                    <a:pt x="1208" y="104"/>
                    <a:pt x="1243" y="104"/>
                  </a:cubicBezTo>
                  <a:cubicBezTo>
                    <a:pt x="1278" y="104"/>
                    <a:pt x="1312" y="6"/>
                    <a:pt x="1347" y="6"/>
                  </a:cubicBezTo>
                  <a:cubicBezTo>
                    <a:pt x="1382" y="6"/>
                    <a:pt x="1416" y="104"/>
                    <a:pt x="1451" y="104"/>
                  </a:cubicBezTo>
                  <a:cubicBezTo>
                    <a:pt x="1486" y="104"/>
                    <a:pt x="1522" y="6"/>
                    <a:pt x="1556" y="6"/>
                  </a:cubicBezTo>
                  <a:cubicBezTo>
                    <a:pt x="1590" y="6"/>
                    <a:pt x="1620" y="104"/>
                    <a:pt x="1654" y="104"/>
                  </a:cubicBezTo>
                  <a:cubicBezTo>
                    <a:pt x="1688" y="104"/>
                    <a:pt x="1724" y="6"/>
                    <a:pt x="1759" y="6"/>
                  </a:cubicBezTo>
                  <a:cubicBezTo>
                    <a:pt x="1794" y="6"/>
                    <a:pt x="1828" y="104"/>
                    <a:pt x="1863" y="104"/>
                  </a:cubicBezTo>
                  <a:cubicBezTo>
                    <a:pt x="1898" y="104"/>
                    <a:pt x="1935" y="6"/>
                    <a:pt x="1967" y="6"/>
                  </a:cubicBezTo>
                  <a:cubicBezTo>
                    <a:pt x="1999" y="6"/>
                    <a:pt x="2026" y="55"/>
                    <a:pt x="2054" y="104"/>
                  </a:cubicBezTo>
                </a:path>
              </a:pathLst>
            </a:custGeom>
            <a:noFill/>
            <a:ln w="19050" cmpd="sng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bg1"/>
                  </a:solidFill>
                </a14:hiddenFill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ja-JP" altLang="en-US">
                <a:solidFill>
                  <a:srgbClr val="000000"/>
                </a:solidFill>
              </a:endParaRPr>
            </a:p>
          </p:txBody>
        </p:sp>
        <p:sp>
          <p:nvSpPr>
            <p:cNvPr id="336" name="Freeform 429"/>
            <p:cNvSpPr>
              <a:spLocks/>
            </p:cNvSpPr>
            <p:nvPr/>
          </p:nvSpPr>
          <p:spPr bwMode="auto">
            <a:xfrm>
              <a:off x="738" y="2049"/>
              <a:ext cx="2054" cy="105"/>
            </a:xfrm>
            <a:custGeom>
              <a:avLst/>
              <a:gdLst>
                <a:gd name="T0" fmla="*/ 0 w 2054"/>
                <a:gd name="T1" fmla="*/ 102 h 105"/>
                <a:gd name="T2" fmla="*/ 101 w 2054"/>
                <a:gd name="T3" fmla="*/ 6 h 105"/>
                <a:gd name="T4" fmla="*/ 205 w 2054"/>
                <a:gd name="T5" fmla="*/ 104 h 105"/>
                <a:gd name="T6" fmla="*/ 309 w 2054"/>
                <a:gd name="T7" fmla="*/ 6 h 105"/>
                <a:gd name="T8" fmla="*/ 414 w 2054"/>
                <a:gd name="T9" fmla="*/ 104 h 105"/>
                <a:gd name="T10" fmla="*/ 524 w 2054"/>
                <a:gd name="T11" fmla="*/ 6 h 105"/>
                <a:gd name="T12" fmla="*/ 622 w 2054"/>
                <a:gd name="T13" fmla="*/ 104 h 105"/>
                <a:gd name="T14" fmla="*/ 727 w 2054"/>
                <a:gd name="T15" fmla="*/ 0 h 105"/>
                <a:gd name="T16" fmla="*/ 831 w 2054"/>
                <a:gd name="T17" fmla="*/ 104 h 105"/>
                <a:gd name="T18" fmla="*/ 930 w 2054"/>
                <a:gd name="T19" fmla="*/ 6 h 105"/>
                <a:gd name="T20" fmla="*/ 1034 w 2054"/>
                <a:gd name="T21" fmla="*/ 104 h 105"/>
                <a:gd name="T22" fmla="*/ 1138 w 2054"/>
                <a:gd name="T23" fmla="*/ 6 h 105"/>
                <a:gd name="T24" fmla="*/ 1243 w 2054"/>
                <a:gd name="T25" fmla="*/ 104 h 105"/>
                <a:gd name="T26" fmla="*/ 1347 w 2054"/>
                <a:gd name="T27" fmla="*/ 6 h 105"/>
                <a:gd name="T28" fmla="*/ 1451 w 2054"/>
                <a:gd name="T29" fmla="*/ 104 h 105"/>
                <a:gd name="T30" fmla="*/ 1556 w 2054"/>
                <a:gd name="T31" fmla="*/ 6 h 105"/>
                <a:gd name="T32" fmla="*/ 1654 w 2054"/>
                <a:gd name="T33" fmla="*/ 104 h 105"/>
                <a:gd name="T34" fmla="*/ 1759 w 2054"/>
                <a:gd name="T35" fmla="*/ 6 h 105"/>
                <a:gd name="T36" fmla="*/ 1863 w 2054"/>
                <a:gd name="T37" fmla="*/ 104 h 105"/>
                <a:gd name="T38" fmla="*/ 1967 w 2054"/>
                <a:gd name="T39" fmla="*/ 6 h 105"/>
                <a:gd name="T40" fmla="*/ 2054 w 2054"/>
                <a:gd name="T41" fmla="*/ 104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2054" h="105">
                  <a:moveTo>
                    <a:pt x="0" y="102"/>
                  </a:moveTo>
                  <a:cubicBezTo>
                    <a:pt x="33" y="54"/>
                    <a:pt x="67" y="6"/>
                    <a:pt x="101" y="6"/>
                  </a:cubicBezTo>
                  <a:cubicBezTo>
                    <a:pt x="135" y="6"/>
                    <a:pt x="170" y="104"/>
                    <a:pt x="205" y="104"/>
                  </a:cubicBezTo>
                  <a:cubicBezTo>
                    <a:pt x="240" y="104"/>
                    <a:pt x="274" y="6"/>
                    <a:pt x="309" y="6"/>
                  </a:cubicBezTo>
                  <a:cubicBezTo>
                    <a:pt x="344" y="6"/>
                    <a:pt x="378" y="104"/>
                    <a:pt x="414" y="104"/>
                  </a:cubicBezTo>
                  <a:cubicBezTo>
                    <a:pt x="450" y="104"/>
                    <a:pt x="489" y="6"/>
                    <a:pt x="524" y="6"/>
                  </a:cubicBezTo>
                  <a:cubicBezTo>
                    <a:pt x="559" y="6"/>
                    <a:pt x="588" y="105"/>
                    <a:pt x="622" y="104"/>
                  </a:cubicBezTo>
                  <a:cubicBezTo>
                    <a:pt x="656" y="103"/>
                    <a:pt x="692" y="0"/>
                    <a:pt x="727" y="0"/>
                  </a:cubicBezTo>
                  <a:cubicBezTo>
                    <a:pt x="762" y="0"/>
                    <a:pt x="797" y="103"/>
                    <a:pt x="831" y="104"/>
                  </a:cubicBezTo>
                  <a:cubicBezTo>
                    <a:pt x="865" y="105"/>
                    <a:pt x="896" y="6"/>
                    <a:pt x="930" y="6"/>
                  </a:cubicBezTo>
                  <a:cubicBezTo>
                    <a:pt x="964" y="6"/>
                    <a:pt x="999" y="104"/>
                    <a:pt x="1034" y="104"/>
                  </a:cubicBezTo>
                  <a:cubicBezTo>
                    <a:pt x="1069" y="104"/>
                    <a:pt x="1103" y="6"/>
                    <a:pt x="1138" y="6"/>
                  </a:cubicBezTo>
                  <a:cubicBezTo>
                    <a:pt x="1173" y="6"/>
                    <a:pt x="1208" y="104"/>
                    <a:pt x="1243" y="104"/>
                  </a:cubicBezTo>
                  <a:cubicBezTo>
                    <a:pt x="1278" y="104"/>
                    <a:pt x="1312" y="6"/>
                    <a:pt x="1347" y="6"/>
                  </a:cubicBezTo>
                  <a:cubicBezTo>
                    <a:pt x="1382" y="6"/>
                    <a:pt x="1416" y="104"/>
                    <a:pt x="1451" y="104"/>
                  </a:cubicBezTo>
                  <a:cubicBezTo>
                    <a:pt x="1486" y="104"/>
                    <a:pt x="1522" y="6"/>
                    <a:pt x="1556" y="6"/>
                  </a:cubicBezTo>
                  <a:cubicBezTo>
                    <a:pt x="1590" y="6"/>
                    <a:pt x="1620" y="104"/>
                    <a:pt x="1654" y="104"/>
                  </a:cubicBezTo>
                  <a:cubicBezTo>
                    <a:pt x="1688" y="104"/>
                    <a:pt x="1724" y="6"/>
                    <a:pt x="1759" y="6"/>
                  </a:cubicBezTo>
                  <a:cubicBezTo>
                    <a:pt x="1794" y="6"/>
                    <a:pt x="1828" y="104"/>
                    <a:pt x="1863" y="104"/>
                  </a:cubicBezTo>
                  <a:cubicBezTo>
                    <a:pt x="1898" y="104"/>
                    <a:pt x="1935" y="6"/>
                    <a:pt x="1967" y="6"/>
                  </a:cubicBezTo>
                  <a:cubicBezTo>
                    <a:pt x="1999" y="6"/>
                    <a:pt x="2026" y="55"/>
                    <a:pt x="2054" y="104"/>
                  </a:cubicBezTo>
                </a:path>
              </a:pathLst>
            </a:custGeom>
            <a:noFill/>
            <a:ln w="19050" cmpd="sng">
              <a:solidFill>
                <a:schemeClr val="tx1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ja-JP" altLang="en-US">
                <a:solidFill>
                  <a:srgbClr val="000000"/>
                </a:solidFill>
              </a:endParaRPr>
            </a:p>
          </p:txBody>
        </p:sp>
      </p:grpSp>
      <p:sp>
        <p:nvSpPr>
          <p:cNvPr id="337" name="正方形/長方形 336"/>
          <p:cNvSpPr/>
          <p:nvPr/>
        </p:nvSpPr>
        <p:spPr>
          <a:xfrm>
            <a:off x="4254862" y="8578731"/>
            <a:ext cx="601903" cy="187556"/>
          </a:xfrm>
          <a:prstGeom prst="rect">
            <a:avLst/>
          </a:prstGeom>
          <a:solidFill>
            <a:srgbClr val="FFFFFF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5" name="Line 6"/>
          <p:cNvSpPr>
            <a:spLocks noChangeShapeType="1"/>
          </p:cNvSpPr>
          <p:nvPr/>
        </p:nvSpPr>
        <p:spPr bwMode="auto">
          <a:xfrm>
            <a:off x="1291093" y="4843590"/>
            <a:ext cx="93208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146" name="Line 6"/>
          <p:cNvSpPr>
            <a:spLocks noChangeShapeType="1"/>
          </p:cNvSpPr>
          <p:nvPr/>
        </p:nvSpPr>
        <p:spPr bwMode="auto">
          <a:xfrm>
            <a:off x="1832417" y="5884101"/>
            <a:ext cx="179214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4487424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640081" y="508000"/>
            <a:ext cx="5608319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charset="0"/>
                <a:ea typeface="Times New Roman" charset="0"/>
                <a:cs typeface="Times New Roman" charset="0"/>
              </a:rPr>
              <a:t>Figure S4. 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ATBF1 is highly expressed in cells at the epithelial zone associated with the expression of E-cadherin. A, Pathological specimens of bladder carcinoma were stained by </a:t>
            </a:r>
            <a:r>
              <a:rPr lang="en-US" altLang="ja-JP" sz="1200" dirty="0" err="1">
                <a:latin typeface="Times New Roman" charset="0"/>
                <a:ea typeface="Times New Roman" charset="0"/>
                <a:cs typeface="Times New Roman" charset="0"/>
              </a:rPr>
              <a:t>hematoxylin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 and eosin, E-cadherin, and anti-ATBF1 antibodies (MB33, MB34, MB39, D10120, MB44, MB47 and MB49). Bladder lumen (L), epithelial zone (E), and mesenchymal zone (M) are shown. A transition from higher expression of ATBF1 in the E zone to lower expression of ATBF1 in the M zone was observed. The basement membrane is not clear between the E and M zones because of invasive cancer. Scale bar = 5 µm. B, Schematic explanation of the function of ATBF1 in inducing E-cadherin. ATBF1 interacts with protein inhibitor of activated STAT3 (PIAS3) to suppress STAT3 signaling [21]. Activation of STAT3 should activate the zinc transporter LIV1 and introduce zinc ions into the cells. The zinc ion is a regulatory factor for Snail to suppress E-cadherin. Therefore, zinc transporters play an important role in the migration of cells during embryogenesis [20]. Fragments of ATBF1 may have a dominant negative effect on suppressing STAT3, whereas they promote STAT3 signaling and suppress the expression of E-cadherin, which might be the basis of invasion and </a:t>
            </a:r>
            <a:r>
              <a:rPr lang="en-US" altLang="ja-JP" sz="1200">
                <a:latin typeface="Times New Roman" charset="0"/>
                <a:ea typeface="Times New Roman" charset="0"/>
                <a:cs typeface="Times New Roman" charset="0"/>
              </a:rPr>
              <a:t>metastasis</a:t>
            </a:r>
            <a:r>
              <a:rPr lang="en-US" altLang="ja-JP" sz="1200" smtClean="0">
                <a:latin typeface="Times New Roman" charset="0"/>
                <a:ea typeface="Times New Roman" charset="0"/>
                <a:cs typeface="Times New Roman" charset="0"/>
              </a:rPr>
              <a:t>.</a:t>
            </a:r>
            <a:endParaRPr lang="ja-JP" altLang="ja-JP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552837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/>
          <p:cNvSpPr txBox="1"/>
          <p:nvPr/>
        </p:nvSpPr>
        <p:spPr>
          <a:xfrm>
            <a:off x="355601" y="862715"/>
            <a:ext cx="6265332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1" algn="just"/>
            <a:r>
              <a:rPr lang="en-US" altLang="ja-JP" sz="1200" b="1" dirty="0">
                <a:latin typeface="Times New Roman"/>
                <a:cs typeface="Times New Roman"/>
              </a:rPr>
              <a:t>Fig. S4. </a:t>
            </a:r>
            <a:r>
              <a:rPr lang="en-US" altLang="ja-JP" sz="1200" dirty="0">
                <a:latin typeface="Times New Roman"/>
                <a:cs typeface="Times New Roman"/>
              </a:rPr>
              <a:t>ATBF1 is highly expressed in cells at the epithelial zone associated with the expression of E-cadherin. A, Pathological specimens of bladder carcinoma were stained by </a:t>
            </a:r>
            <a:r>
              <a:rPr lang="en-US" altLang="ja-JP" sz="1200" dirty="0" err="1">
                <a:latin typeface="Times New Roman"/>
                <a:cs typeface="Times New Roman"/>
              </a:rPr>
              <a:t>hematoxylin</a:t>
            </a:r>
            <a:r>
              <a:rPr lang="en-US" altLang="ja-JP" sz="1200" dirty="0">
                <a:latin typeface="Times New Roman"/>
                <a:cs typeface="Times New Roman"/>
              </a:rPr>
              <a:t> and eosin, E-cadherin, and anti-ATBF1 antibodies (MB33, MB34, MB39, D10120, MB44, MB47 and MB49). Bladder lumen (L), epithelial zone (E) and </a:t>
            </a:r>
            <a:r>
              <a:rPr lang="en-US" altLang="ja-JP" sz="1200" dirty="0" err="1">
                <a:latin typeface="Times New Roman"/>
                <a:cs typeface="Times New Roman"/>
              </a:rPr>
              <a:t>mesenchymal</a:t>
            </a:r>
            <a:r>
              <a:rPr lang="en-US" altLang="ja-JP" sz="1200" dirty="0">
                <a:latin typeface="Times New Roman"/>
                <a:cs typeface="Times New Roman"/>
              </a:rPr>
              <a:t> zone (M) are shown. A transition from higher expression of ATBF1 in the E zone to lower expression of ATBF1 in the M zone was observed. The basement membrane is not clear between the E and M zones because of invasive cancer. Scale bar = 5 µm. B, Schematic explanation of the function of ATBF1 in inducing E-</a:t>
            </a:r>
            <a:r>
              <a:rPr lang="en-US" altLang="ja-JP" sz="1200" dirty="0" err="1">
                <a:latin typeface="Times New Roman"/>
                <a:cs typeface="Times New Roman"/>
              </a:rPr>
              <a:t>cadherin</a:t>
            </a:r>
            <a:r>
              <a:rPr lang="en-US" altLang="ja-JP" sz="1200" dirty="0">
                <a:latin typeface="Times New Roman"/>
                <a:cs typeface="Times New Roman"/>
              </a:rPr>
              <a:t>. ATBF1 interacts with protein inhibitor of activated STAT3 (PIAS3) to suppress STAT3 signaling [21]. Activation of STAT3 should activate the zinc transporter LIV1 and introduce zinc ions into the cells. The zinc ion is a regulatory factor for Snail to suppress E-cadherin. Therefore, zinc transporters play an important role in the migration of cells during embryogenesis [20]. Fragments of ATBF1 may have a dominant negative effect on suppressing STAT3, whereas they promote STAT3 signaling and suppress the expression of E-cadherin, which might be the basis of invasion and metastasis.</a:t>
            </a:r>
            <a:endParaRPr lang="ja-JP" altLang="ja-JP" sz="12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244063404"/>
      </p:ext>
    </p:extLst>
  </p:cSld>
  <p:clrMapOvr>
    <a:masterClrMapping/>
  </p:clrMapOvr>
</p:sld>
</file>

<file path=ppt/theme/theme1.xml><?xml version="1.0" encoding="utf-8"?>
<a:theme xmlns:a="http://schemas.openxmlformats.org/drawingml/2006/main" name="金沢 Discussion Ver.8 Molecular Cancer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金沢 Discussion Ver.8 Molecular Cancer.potx</Template>
  <TotalTime>93494</TotalTime>
  <Words>534</Words>
  <Application>Microsoft Macintosh PowerPoint</Application>
  <PresentationFormat>画面に合わせる (4:3)</PresentationFormat>
  <Paragraphs>43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11" baseType="lpstr">
      <vt:lpstr>Calibri</vt:lpstr>
      <vt:lpstr>ＭＳ Ｐゴシック</vt:lpstr>
      <vt:lpstr>ＭＳ ゴシック</vt:lpstr>
      <vt:lpstr>Times</vt:lpstr>
      <vt:lpstr>Times New Roman</vt:lpstr>
      <vt:lpstr>ヒラギノ明朝 Pro W3</vt:lpstr>
      <vt:lpstr>Arial</vt:lpstr>
      <vt:lpstr>金沢 Discussion Ver.8 Molecular Cancer</vt:lpstr>
      <vt:lpstr>PowerPoint プレゼンテーション</vt:lpstr>
      <vt:lpstr>PowerPoint プレゼンテーション</vt:lpstr>
      <vt:lpstr>PowerPoint プレゼンテーション</vt:lpstr>
    </vt:vector>
  </TitlesOfParts>
  <Company>新潟労災病院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川口 誠</dc:creator>
  <cp:lastModifiedBy>川口誠</cp:lastModifiedBy>
  <cp:revision>847</cp:revision>
  <cp:lastPrinted>2015-04-15T06:21:33Z</cp:lastPrinted>
  <dcterms:created xsi:type="dcterms:W3CDTF">2015-04-12T21:26:12Z</dcterms:created>
  <dcterms:modified xsi:type="dcterms:W3CDTF">2016-09-24T00:39:43Z</dcterms:modified>
</cp:coreProperties>
</file>